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1" r:id="rId1"/>
  </p:sldMasterIdLst>
  <p:notesMasterIdLst>
    <p:notesMasterId r:id="rId6"/>
  </p:notesMasterIdLst>
  <p:sldIdLst>
    <p:sldId id="508" r:id="rId2"/>
    <p:sldId id="496" r:id="rId3"/>
    <p:sldId id="493" r:id="rId4"/>
    <p:sldId id="50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898DDC0-84E3-2A9A-2092-AACB035A52B6}" name="Thomas Waksman" initials="TW" userId="Thomas Waksman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hn Christie" initials="JC" lastIdx="2" clrIdx="0">
    <p:extLst>
      <p:ext uri="{19B8F6BF-5375-455C-9EA6-DF929625EA0E}">
        <p15:presenceInfo xmlns:p15="http://schemas.microsoft.com/office/powerpoint/2012/main" userId="S::john.christie@glasgow.ac.uk::46fd518a-f1b7-48ed-a6d4-65845e91c67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241"/>
    <p:restoredTop sz="95714"/>
  </p:normalViewPr>
  <p:slideViewPr>
    <p:cSldViewPr snapToGrid="0" snapToObjects="1">
      <p:cViewPr varScale="1">
        <p:scale>
          <a:sx n="85" d="100"/>
          <a:sy n="85" d="100"/>
        </p:scale>
        <p:origin x="344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Users/stuart1/Documents/mass%20spec%20results/RPT2_NCH1/RPT2_IPs_graph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ohnchristie/Desktop/RPT2%20Paper%20/RPT2_Abundanc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uart1/Documents/papers/RPT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graphs-rep2'!$C$1</c:f>
              <c:strCache>
                <c:ptCount val="1"/>
                <c:pt idx="0">
                  <c:v>Dark-nor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raphs-rep2'!$E$2:$E$9</c:f>
                <c:numCache>
                  <c:formatCode>General</c:formatCode>
                  <c:ptCount val="8"/>
                </c:numCache>
              </c:numRef>
            </c:plus>
            <c:minus>
              <c:numRef>
                <c:f>'graphs-rep2'!$E$2:$E$9</c:f>
                <c:numCache>
                  <c:formatCode>General</c:formatCode>
                  <c:ptCount val="8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phs-rep2'!$B$2:$B$10</c:f>
              <c:strCache>
                <c:ptCount val="9"/>
                <c:pt idx="0">
                  <c:v>14-3-3 Lambda/GRF6</c:v>
                </c:pt>
                <c:pt idx="1">
                  <c:v>14-3-3 Chi/GRF1</c:v>
                </c:pt>
                <c:pt idx="2">
                  <c:v>14-3-3 Epsilon/GRF10</c:v>
                </c:pt>
                <c:pt idx="3">
                  <c:v>14-3-3 Omega/GRF2</c:v>
                </c:pt>
                <c:pt idx="4">
                  <c:v>14-3-3 Upsilon/GRF5</c:v>
                </c:pt>
                <c:pt idx="5">
                  <c:v>14-3-3 Nu/GRF7</c:v>
                </c:pt>
                <c:pt idx="6">
                  <c:v>14-3-3 Kappa/GRF8</c:v>
                </c:pt>
                <c:pt idx="7">
                  <c:v>14-3-3 Mu/GRF9</c:v>
                </c:pt>
                <c:pt idx="8">
                  <c:v>14-3-3 Phi/GRF4</c:v>
                </c:pt>
              </c:strCache>
            </c:strRef>
          </c:cat>
          <c:val>
            <c:numRef>
              <c:f>'graphs-rep2'!$C$2:$C$10</c:f>
              <c:numCache>
                <c:formatCode>General</c:formatCode>
                <c:ptCount val="9"/>
                <c:pt idx="0">
                  <c:v>7.5052204522403201E-2</c:v>
                </c:pt>
                <c:pt idx="1">
                  <c:v>1.0344848159417697</c:v>
                </c:pt>
                <c:pt idx="2">
                  <c:v>0.29556410715351111</c:v>
                </c:pt>
                <c:pt idx="3">
                  <c:v>0.11905912535051608</c:v>
                </c:pt>
                <c:pt idx="4">
                  <c:v>0.1222361434281964</c:v>
                </c:pt>
                <c:pt idx="5">
                  <c:v>0.12007636775848696</c:v>
                </c:pt>
                <c:pt idx="6">
                  <c:v>0.115237754310602</c:v>
                </c:pt>
                <c:pt idx="7">
                  <c:v>0.36916055127975661</c:v>
                </c:pt>
                <c:pt idx="8">
                  <c:v>0.167376648171350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36-E84F-8DA9-222431856CAD}"/>
            </c:ext>
          </c:extLst>
        </c:ser>
        <c:ser>
          <c:idx val="1"/>
          <c:order val="1"/>
          <c:tx>
            <c:strRef>
              <c:f>'graphs-rep2'!$D$1</c:f>
              <c:strCache>
                <c:ptCount val="1"/>
                <c:pt idx="0">
                  <c:v>Light-norm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raphs-rep2'!$F$2:$F$9</c:f>
                <c:numCache>
                  <c:formatCode>General</c:formatCode>
                  <c:ptCount val="8"/>
                </c:numCache>
              </c:numRef>
            </c:plus>
            <c:minus>
              <c:numRef>
                <c:f>'graphs-rep2'!$F$2:$F$9</c:f>
                <c:numCache>
                  <c:formatCode>General</c:formatCode>
                  <c:ptCount val="8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raphs-rep2'!$B$2:$B$10</c:f>
              <c:strCache>
                <c:ptCount val="9"/>
                <c:pt idx="0">
                  <c:v>14-3-3 Lambda/GRF6</c:v>
                </c:pt>
                <c:pt idx="1">
                  <c:v>14-3-3 Chi/GRF1</c:v>
                </c:pt>
                <c:pt idx="2">
                  <c:v>14-3-3 Epsilon/GRF10</c:v>
                </c:pt>
                <c:pt idx="3">
                  <c:v>14-3-3 Omega/GRF2</c:v>
                </c:pt>
                <c:pt idx="4">
                  <c:v>14-3-3 Upsilon/GRF5</c:v>
                </c:pt>
                <c:pt idx="5">
                  <c:v>14-3-3 Nu/GRF7</c:v>
                </c:pt>
                <c:pt idx="6">
                  <c:v>14-3-3 Kappa/GRF8</c:v>
                </c:pt>
                <c:pt idx="7">
                  <c:v>14-3-3 Mu/GRF9</c:v>
                </c:pt>
                <c:pt idx="8">
                  <c:v>14-3-3 Phi/GRF4</c:v>
                </c:pt>
              </c:strCache>
            </c:strRef>
          </c:cat>
          <c:val>
            <c:numRef>
              <c:f>'graphs-rep2'!$D$2:$D$10</c:f>
              <c:numCache>
                <c:formatCode>General</c:formatCode>
                <c:ptCount val="9"/>
                <c:pt idx="0">
                  <c:v>0.13097822676789861</c:v>
                </c:pt>
                <c:pt idx="1">
                  <c:v>1.7891071092426429</c:v>
                </c:pt>
                <c:pt idx="2">
                  <c:v>0.42522432076300437</c:v>
                </c:pt>
                <c:pt idx="3">
                  <c:v>0.21375415699316055</c:v>
                </c:pt>
                <c:pt idx="4">
                  <c:v>0.32836167409173622</c:v>
                </c:pt>
                <c:pt idx="5">
                  <c:v>0.24836543891573068</c:v>
                </c:pt>
                <c:pt idx="6">
                  <c:v>0.14989646734015186</c:v>
                </c:pt>
                <c:pt idx="7">
                  <c:v>0.33080253498148965</c:v>
                </c:pt>
                <c:pt idx="8">
                  <c:v>0.132521804605634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36-E84F-8DA9-222431856C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70477672"/>
        <c:axId val="394908776"/>
      </c:barChart>
      <c:catAx>
        <c:axId val="370477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800"/>
            </a:pPr>
            <a:endParaRPr lang="en-US"/>
          </a:p>
        </c:txPr>
        <c:crossAx val="394908776"/>
        <c:crosses val="autoZero"/>
        <c:auto val="1"/>
        <c:lblAlgn val="ctr"/>
        <c:lblOffset val="100"/>
        <c:noMultiLvlLbl val="0"/>
      </c:catAx>
      <c:valAx>
        <c:axId val="394908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sz="700"/>
            </a:pPr>
            <a:endParaRPr lang="en-US"/>
          </a:p>
        </c:txPr>
        <c:crossAx val="37047767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6338659571850391"/>
          <c:y val="0.15255124208215501"/>
          <c:w val="0.26710701689632543"/>
          <c:h val="0.14560945491687691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22167523146828"/>
          <c:y val="0.11701756639758124"/>
          <c:w val="0.80613315171838651"/>
          <c:h val="0.73015289739662215"/>
        </c:manualLayout>
      </c:layout>
      <c:scatterChart>
        <c:scatterStyle val="lineMarker"/>
        <c:varyColors val="0"/>
        <c:ser>
          <c:idx val="0"/>
          <c:order val="0"/>
          <c:tx>
            <c:v>WT</c:v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B$25:$B$28</c:f>
                <c:numCache>
                  <c:formatCode>General</c:formatCode>
                  <c:ptCount val="4"/>
                  <c:pt idx="0">
                    <c:v>0.15374398149909699</c:v>
                  </c:pt>
                  <c:pt idx="1">
                    <c:v>0.52250349138154006</c:v>
                  </c:pt>
                  <c:pt idx="2">
                    <c:v>1.1090148866448197</c:v>
                  </c:pt>
                  <c:pt idx="3">
                    <c:v>1.1100000000000001</c:v>
                  </c:pt>
                </c:numCache>
              </c:numRef>
            </c:plus>
            <c:minus>
              <c:numRef>
                <c:f>Summary!$B$25:$B$28</c:f>
                <c:numCache>
                  <c:formatCode>General</c:formatCode>
                  <c:ptCount val="4"/>
                  <c:pt idx="0">
                    <c:v>0.15374398149909699</c:v>
                  </c:pt>
                  <c:pt idx="1">
                    <c:v>0.52250349138154006</c:v>
                  </c:pt>
                  <c:pt idx="2">
                    <c:v>1.1090148866448197</c:v>
                  </c:pt>
                  <c:pt idx="3">
                    <c:v>1.11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Lit>
              <c:formatCode>General</c:formatCode>
              <c:ptCount val="4"/>
              <c:pt idx="0">
                <c:v>0</c:v>
              </c:pt>
              <c:pt idx="1">
                <c:v>0.5</c:v>
              </c:pt>
              <c:pt idx="2">
                <c:v>1</c:v>
              </c:pt>
              <c:pt idx="3">
                <c:v>2</c:v>
              </c:pt>
            </c:numLit>
          </c:xVal>
          <c:yVal>
            <c:numRef>
              <c:f>(mRNA!$G$2,mRNA!$G$8,mRNA!$G$14,mRNA!$G$20)</c:f>
              <c:numCache>
                <c:formatCode>0.00</c:formatCode>
                <c:ptCount val="4"/>
                <c:pt idx="0">
                  <c:v>0.43538214538702819</c:v>
                </c:pt>
                <c:pt idx="1">
                  <c:v>2.1783113035667729</c:v>
                </c:pt>
                <c:pt idx="2">
                  <c:v>5.3504353827722069</c:v>
                </c:pt>
                <c:pt idx="3">
                  <c:v>7.18151812150445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F5E-E64A-B16B-5A4F1B601852}"/>
            </c:ext>
          </c:extLst>
        </c:ser>
        <c:ser>
          <c:idx val="1"/>
          <c:order val="1"/>
          <c:tx>
            <c:v>phot1phot2</c:v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mmary!$C$25:$C$28</c:f>
                <c:numCache>
                  <c:formatCode>General</c:formatCode>
                  <c:ptCount val="4"/>
                  <c:pt idx="0">
                    <c:v>0.10453712778783139</c:v>
                  </c:pt>
                  <c:pt idx="1">
                    <c:v>0.55638977501523301</c:v>
                  </c:pt>
                  <c:pt idx="2">
                    <c:v>1.1415253038126005</c:v>
                  </c:pt>
                  <c:pt idx="3">
                    <c:v>0.96</c:v>
                  </c:pt>
                </c:numCache>
              </c:numRef>
            </c:plus>
            <c:minus>
              <c:numRef>
                <c:f>Summary!$C$25:$C$28</c:f>
                <c:numCache>
                  <c:formatCode>General</c:formatCode>
                  <c:ptCount val="4"/>
                  <c:pt idx="0">
                    <c:v>0.10453712778783139</c:v>
                  </c:pt>
                  <c:pt idx="1">
                    <c:v>0.55638977501523301</c:v>
                  </c:pt>
                  <c:pt idx="2">
                    <c:v>1.1415253038126005</c:v>
                  </c:pt>
                  <c:pt idx="3">
                    <c:v>0.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Lit>
              <c:formatCode>General</c:formatCode>
              <c:ptCount val="4"/>
              <c:pt idx="0">
                <c:v>0</c:v>
              </c:pt>
              <c:pt idx="1">
                <c:v>0.5</c:v>
              </c:pt>
              <c:pt idx="2">
                <c:v>1</c:v>
              </c:pt>
              <c:pt idx="3">
                <c:v>2</c:v>
              </c:pt>
            </c:numLit>
          </c:xVal>
          <c:yVal>
            <c:numRef>
              <c:f>(mRNA!$G$26,mRNA!$G$32,mRNA!$G$39,mRNA!$G$45)</c:f>
              <c:numCache>
                <c:formatCode>0.00</c:formatCode>
                <c:ptCount val="4"/>
                <c:pt idx="0">
                  <c:v>0.30439650343008307</c:v>
                </c:pt>
                <c:pt idx="1">
                  <c:v>1.9871402882584064</c:v>
                </c:pt>
                <c:pt idx="2">
                  <c:v>4.9281412081433613</c:v>
                </c:pt>
                <c:pt idx="3">
                  <c:v>5.85195854351537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F5E-E64A-B16B-5A4F1B6018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2320143"/>
        <c:axId val="1802358495"/>
      </c:scatterChart>
      <c:valAx>
        <c:axId val="1802320143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2358495"/>
        <c:crosses val="autoZero"/>
        <c:crossBetween val="midCat"/>
      </c:valAx>
      <c:valAx>
        <c:axId val="1802358495"/>
        <c:scaling>
          <c:orientation val="minMax"/>
          <c:max val="9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2320143"/>
        <c:crosses val="autoZero"/>
        <c:crossBetween val="midCat"/>
        <c:minorUnit val="1"/>
      </c:valAx>
      <c:spPr>
        <a:noFill/>
        <a:ln>
          <a:noFill/>
        </a:ln>
        <a:effectLst/>
      </c:spPr>
    </c:plotArea>
    <c:legend>
      <c:legendPos val="t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68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680" b="0" i="1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15160769664116364"/>
          <c:y val="0.11217983639136117"/>
          <c:w val="0.30726584037082827"/>
          <c:h val="0.13501927896046939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2"/>
          <c:order val="0"/>
          <c:tx>
            <c:v>PrDOS</c:v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yVal>
            <c:numRef>
              <c:f>Sheet1!$E$2:$E$594</c:f>
              <c:numCache>
                <c:formatCode>General</c:formatCode>
                <c:ptCount val="593"/>
                <c:pt idx="0">
                  <c:v>0.95</c:v>
                </c:pt>
                <c:pt idx="1">
                  <c:v>0.95</c:v>
                </c:pt>
                <c:pt idx="2">
                  <c:v>0.95</c:v>
                </c:pt>
                <c:pt idx="3">
                  <c:v>0.96</c:v>
                </c:pt>
                <c:pt idx="4">
                  <c:v>0.95</c:v>
                </c:pt>
                <c:pt idx="5">
                  <c:v>0.94</c:v>
                </c:pt>
                <c:pt idx="6">
                  <c:v>0.93</c:v>
                </c:pt>
                <c:pt idx="7">
                  <c:v>0.93</c:v>
                </c:pt>
                <c:pt idx="8">
                  <c:v>0.92</c:v>
                </c:pt>
                <c:pt idx="9">
                  <c:v>0.91</c:v>
                </c:pt>
                <c:pt idx="10">
                  <c:v>0.9</c:v>
                </c:pt>
                <c:pt idx="11">
                  <c:v>0.86</c:v>
                </c:pt>
                <c:pt idx="12">
                  <c:v>0.8</c:v>
                </c:pt>
                <c:pt idx="13">
                  <c:v>0.74</c:v>
                </c:pt>
                <c:pt idx="14">
                  <c:v>0.67</c:v>
                </c:pt>
                <c:pt idx="15">
                  <c:v>0.61</c:v>
                </c:pt>
                <c:pt idx="16">
                  <c:v>0.56000000000000005</c:v>
                </c:pt>
                <c:pt idx="17">
                  <c:v>0.51</c:v>
                </c:pt>
                <c:pt idx="18">
                  <c:v>0.46</c:v>
                </c:pt>
                <c:pt idx="19">
                  <c:v>0.45</c:v>
                </c:pt>
                <c:pt idx="20">
                  <c:v>0.42</c:v>
                </c:pt>
                <c:pt idx="21">
                  <c:v>0.4</c:v>
                </c:pt>
                <c:pt idx="22">
                  <c:v>0.4</c:v>
                </c:pt>
                <c:pt idx="23">
                  <c:v>0.38</c:v>
                </c:pt>
                <c:pt idx="24">
                  <c:v>0.36</c:v>
                </c:pt>
                <c:pt idx="25">
                  <c:v>0.33</c:v>
                </c:pt>
                <c:pt idx="26">
                  <c:v>0.31</c:v>
                </c:pt>
                <c:pt idx="27">
                  <c:v>0.27</c:v>
                </c:pt>
                <c:pt idx="28">
                  <c:v>0.23</c:v>
                </c:pt>
                <c:pt idx="29">
                  <c:v>0.17</c:v>
                </c:pt>
                <c:pt idx="30">
                  <c:v>0.1</c:v>
                </c:pt>
                <c:pt idx="31">
                  <c:v>0.09</c:v>
                </c:pt>
                <c:pt idx="32">
                  <c:v>0.08</c:v>
                </c:pt>
                <c:pt idx="33">
                  <c:v>7.0000000000000007E-2</c:v>
                </c:pt>
                <c:pt idx="34">
                  <c:v>7.0000000000000007E-2</c:v>
                </c:pt>
                <c:pt idx="35">
                  <c:v>7.0000000000000007E-2</c:v>
                </c:pt>
                <c:pt idx="36">
                  <c:v>7.0000000000000007E-2</c:v>
                </c:pt>
                <c:pt idx="37">
                  <c:v>0.08</c:v>
                </c:pt>
                <c:pt idx="38">
                  <c:v>0.08</c:v>
                </c:pt>
                <c:pt idx="39">
                  <c:v>0.09</c:v>
                </c:pt>
                <c:pt idx="40">
                  <c:v>0.09</c:v>
                </c:pt>
                <c:pt idx="41">
                  <c:v>0.09</c:v>
                </c:pt>
                <c:pt idx="42">
                  <c:v>0.09</c:v>
                </c:pt>
                <c:pt idx="43">
                  <c:v>0.08</c:v>
                </c:pt>
                <c:pt idx="44">
                  <c:v>0.08</c:v>
                </c:pt>
                <c:pt idx="45">
                  <c:v>0.09</c:v>
                </c:pt>
                <c:pt idx="46">
                  <c:v>0.09</c:v>
                </c:pt>
                <c:pt idx="47">
                  <c:v>0.09</c:v>
                </c:pt>
                <c:pt idx="48">
                  <c:v>0.09</c:v>
                </c:pt>
                <c:pt idx="49">
                  <c:v>0.1</c:v>
                </c:pt>
                <c:pt idx="50">
                  <c:v>0.1</c:v>
                </c:pt>
                <c:pt idx="51">
                  <c:v>0.13</c:v>
                </c:pt>
                <c:pt idx="52">
                  <c:v>0.16</c:v>
                </c:pt>
                <c:pt idx="53">
                  <c:v>0.19</c:v>
                </c:pt>
                <c:pt idx="54">
                  <c:v>0.21</c:v>
                </c:pt>
                <c:pt idx="55">
                  <c:v>0.23</c:v>
                </c:pt>
                <c:pt idx="56">
                  <c:v>0.25</c:v>
                </c:pt>
                <c:pt idx="57">
                  <c:v>0.27</c:v>
                </c:pt>
                <c:pt idx="58">
                  <c:v>0.31</c:v>
                </c:pt>
                <c:pt idx="59">
                  <c:v>0.34</c:v>
                </c:pt>
                <c:pt idx="60">
                  <c:v>0.38</c:v>
                </c:pt>
                <c:pt idx="61">
                  <c:v>0.42</c:v>
                </c:pt>
                <c:pt idx="62">
                  <c:v>0.45</c:v>
                </c:pt>
                <c:pt idx="63">
                  <c:v>0.49</c:v>
                </c:pt>
                <c:pt idx="64">
                  <c:v>0.54</c:v>
                </c:pt>
                <c:pt idx="65">
                  <c:v>0.54</c:v>
                </c:pt>
                <c:pt idx="66">
                  <c:v>0.54</c:v>
                </c:pt>
                <c:pt idx="67">
                  <c:v>0.49</c:v>
                </c:pt>
                <c:pt idx="68">
                  <c:v>0.45</c:v>
                </c:pt>
                <c:pt idx="69">
                  <c:v>0.42</c:v>
                </c:pt>
                <c:pt idx="70">
                  <c:v>0.39</c:v>
                </c:pt>
                <c:pt idx="71">
                  <c:v>0.36</c:v>
                </c:pt>
                <c:pt idx="72">
                  <c:v>0.32</c:v>
                </c:pt>
                <c:pt idx="73">
                  <c:v>0.28999999999999998</c:v>
                </c:pt>
                <c:pt idx="74">
                  <c:v>0.26</c:v>
                </c:pt>
                <c:pt idx="75">
                  <c:v>0.24</c:v>
                </c:pt>
                <c:pt idx="76">
                  <c:v>0.22</c:v>
                </c:pt>
                <c:pt idx="77">
                  <c:v>0.19</c:v>
                </c:pt>
                <c:pt idx="78">
                  <c:v>0.17</c:v>
                </c:pt>
                <c:pt idx="79">
                  <c:v>0.15</c:v>
                </c:pt>
                <c:pt idx="80">
                  <c:v>0.11</c:v>
                </c:pt>
                <c:pt idx="81">
                  <c:v>0.1</c:v>
                </c:pt>
                <c:pt idx="82">
                  <c:v>0.09</c:v>
                </c:pt>
                <c:pt idx="83">
                  <c:v>0.08</c:v>
                </c:pt>
                <c:pt idx="84">
                  <c:v>7.0000000000000007E-2</c:v>
                </c:pt>
                <c:pt idx="85">
                  <c:v>0.06</c:v>
                </c:pt>
                <c:pt idx="86">
                  <c:v>0.05</c:v>
                </c:pt>
                <c:pt idx="87">
                  <c:v>0.05</c:v>
                </c:pt>
                <c:pt idx="88">
                  <c:v>0.05</c:v>
                </c:pt>
                <c:pt idx="89">
                  <c:v>0.05</c:v>
                </c:pt>
                <c:pt idx="90">
                  <c:v>0.05</c:v>
                </c:pt>
                <c:pt idx="91">
                  <c:v>0.06</c:v>
                </c:pt>
                <c:pt idx="92">
                  <c:v>7.0000000000000007E-2</c:v>
                </c:pt>
                <c:pt idx="93">
                  <c:v>0.08</c:v>
                </c:pt>
                <c:pt idx="94">
                  <c:v>0.09</c:v>
                </c:pt>
                <c:pt idx="95">
                  <c:v>0.09</c:v>
                </c:pt>
                <c:pt idx="96">
                  <c:v>0.1</c:v>
                </c:pt>
                <c:pt idx="97">
                  <c:v>0.1</c:v>
                </c:pt>
                <c:pt idx="98">
                  <c:v>0.1</c:v>
                </c:pt>
                <c:pt idx="99">
                  <c:v>0.1</c:v>
                </c:pt>
                <c:pt idx="100">
                  <c:v>0.1</c:v>
                </c:pt>
                <c:pt idx="101">
                  <c:v>0.1</c:v>
                </c:pt>
                <c:pt idx="102">
                  <c:v>0.1</c:v>
                </c:pt>
                <c:pt idx="103">
                  <c:v>0.09</c:v>
                </c:pt>
                <c:pt idx="104">
                  <c:v>0.09</c:v>
                </c:pt>
                <c:pt idx="105">
                  <c:v>0.09</c:v>
                </c:pt>
                <c:pt idx="106">
                  <c:v>0.09</c:v>
                </c:pt>
                <c:pt idx="107">
                  <c:v>0.09</c:v>
                </c:pt>
                <c:pt idx="108">
                  <c:v>0.1</c:v>
                </c:pt>
                <c:pt idx="109">
                  <c:v>0.11</c:v>
                </c:pt>
                <c:pt idx="110">
                  <c:v>0.14000000000000001</c:v>
                </c:pt>
                <c:pt idx="111">
                  <c:v>0.19</c:v>
                </c:pt>
                <c:pt idx="112">
                  <c:v>0.23</c:v>
                </c:pt>
                <c:pt idx="113">
                  <c:v>0.28000000000000003</c:v>
                </c:pt>
                <c:pt idx="114">
                  <c:v>0.31</c:v>
                </c:pt>
                <c:pt idx="115">
                  <c:v>0.34</c:v>
                </c:pt>
                <c:pt idx="116">
                  <c:v>0.36</c:v>
                </c:pt>
                <c:pt idx="117">
                  <c:v>0.39</c:v>
                </c:pt>
                <c:pt idx="118">
                  <c:v>0.4</c:v>
                </c:pt>
                <c:pt idx="119">
                  <c:v>0.41</c:v>
                </c:pt>
                <c:pt idx="120">
                  <c:v>0.41</c:v>
                </c:pt>
                <c:pt idx="121">
                  <c:v>0.4</c:v>
                </c:pt>
                <c:pt idx="122">
                  <c:v>0.39</c:v>
                </c:pt>
                <c:pt idx="123">
                  <c:v>0.37</c:v>
                </c:pt>
                <c:pt idx="124">
                  <c:v>0.35</c:v>
                </c:pt>
                <c:pt idx="125">
                  <c:v>0.33</c:v>
                </c:pt>
                <c:pt idx="126">
                  <c:v>0.3</c:v>
                </c:pt>
                <c:pt idx="127">
                  <c:v>0.28000000000000003</c:v>
                </c:pt>
                <c:pt idx="128">
                  <c:v>0.25</c:v>
                </c:pt>
                <c:pt idx="129">
                  <c:v>0.22</c:v>
                </c:pt>
                <c:pt idx="130">
                  <c:v>0.2</c:v>
                </c:pt>
                <c:pt idx="131">
                  <c:v>0.18</c:v>
                </c:pt>
                <c:pt idx="132">
                  <c:v>0.16</c:v>
                </c:pt>
                <c:pt idx="133">
                  <c:v>0.14000000000000001</c:v>
                </c:pt>
                <c:pt idx="134">
                  <c:v>0.13</c:v>
                </c:pt>
                <c:pt idx="135">
                  <c:v>0.11</c:v>
                </c:pt>
                <c:pt idx="136">
                  <c:v>0.12</c:v>
                </c:pt>
                <c:pt idx="137">
                  <c:v>0.12</c:v>
                </c:pt>
                <c:pt idx="138">
                  <c:v>0.13</c:v>
                </c:pt>
                <c:pt idx="139">
                  <c:v>0.13</c:v>
                </c:pt>
                <c:pt idx="140">
                  <c:v>0.13</c:v>
                </c:pt>
                <c:pt idx="141">
                  <c:v>0.13</c:v>
                </c:pt>
                <c:pt idx="142">
                  <c:v>0.14000000000000001</c:v>
                </c:pt>
                <c:pt idx="143">
                  <c:v>0.14000000000000001</c:v>
                </c:pt>
                <c:pt idx="144">
                  <c:v>0.14000000000000001</c:v>
                </c:pt>
                <c:pt idx="145">
                  <c:v>0.14000000000000001</c:v>
                </c:pt>
                <c:pt idx="146">
                  <c:v>0.16</c:v>
                </c:pt>
                <c:pt idx="147">
                  <c:v>0.19</c:v>
                </c:pt>
                <c:pt idx="148">
                  <c:v>0.22</c:v>
                </c:pt>
                <c:pt idx="149">
                  <c:v>0.24</c:v>
                </c:pt>
                <c:pt idx="150">
                  <c:v>0.25</c:v>
                </c:pt>
                <c:pt idx="151">
                  <c:v>0.27</c:v>
                </c:pt>
                <c:pt idx="152">
                  <c:v>0.28999999999999998</c:v>
                </c:pt>
                <c:pt idx="153">
                  <c:v>0.3</c:v>
                </c:pt>
                <c:pt idx="154">
                  <c:v>0.3</c:v>
                </c:pt>
                <c:pt idx="155">
                  <c:v>0.3</c:v>
                </c:pt>
                <c:pt idx="156">
                  <c:v>0.28999999999999998</c:v>
                </c:pt>
                <c:pt idx="157">
                  <c:v>0.28000000000000003</c:v>
                </c:pt>
                <c:pt idx="158">
                  <c:v>0.26</c:v>
                </c:pt>
                <c:pt idx="159">
                  <c:v>0.23</c:v>
                </c:pt>
                <c:pt idx="160">
                  <c:v>0.19</c:v>
                </c:pt>
                <c:pt idx="161">
                  <c:v>0.14000000000000001</c:v>
                </c:pt>
                <c:pt idx="162">
                  <c:v>0.1</c:v>
                </c:pt>
                <c:pt idx="163">
                  <c:v>0.1</c:v>
                </c:pt>
                <c:pt idx="164">
                  <c:v>0.09</c:v>
                </c:pt>
                <c:pt idx="165">
                  <c:v>0.09</c:v>
                </c:pt>
                <c:pt idx="166">
                  <c:v>0.09</c:v>
                </c:pt>
                <c:pt idx="167">
                  <c:v>0.1</c:v>
                </c:pt>
                <c:pt idx="168">
                  <c:v>0.13</c:v>
                </c:pt>
                <c:pt idx="169">
                  <c:v>0.17</c:v>
                </c:pt>
                <c:pt idx="170">
                  <c:v>0.21</c:v>
                </c:pt>
                <c:pt idx="171">
                  <c:v>0.26</c:v>
                </c:pt>
                <c:pt idx="172">
                  <c:v>0.3</c:v>
                </c:pt>
                <c:pt idx="173">
                  <c:v>0.34</c:v>
                </c:pt>
                <c:pt idx="174">
                  <c:v>0.37</c:v>
                </c:pt>
                <c:pt idx="175">
                  <c:v>0.4</c:v>
                </c:pt>
                <c:pt idx="176">
                  <c:v>0.42</c:v>
                </c:pt>
                <c:pt idx="177">
                  <c:v>0.43</c:v>
                </c:pt>
                <c:pt idx="178">
                  <c:v>0.43</c:v>
                </c:pt>
                <c:pt idx="179">
                  <c:v>0.44</c:v>
                </c:pt>
                <c:pt idx="180">
                  <c:v>0.45</c:v>
                </c:pt>
                <c:pt idx="181">
                  <c:v>0.45</c:v>
                </c:pt>
                <c:pt idx="182">
                  <c:v>0.44</c:v>
                </c:pt>
                <c:pt idx="183">
                  <c:v>0.42</c:v>
                </c:pt>
                <c:pt idx="184">
                  <c:v>0.39</c:v>
                </c:pt>
                <c:pt idx="185">
                  <c:v>0.35</c:v>
                </c:pt>
                <c:pt idx="186">
                  <c:v>0.33</c:v>
                </c:pt>
                <c:pt idx="187">
                  <c:v>0.3</c:v>
                </c:pt>
                <c:pt idx="188">
                  <c:v>0.26</c:v>
                </c:pt>
                <c:pt idx="189">
                  <c:v>0.24</c:v>
                </c:pt>
                <c:pt idx="190">
                  <c:v>0.22</c:v>
                </c:pt>
                <c:pt idx="191">
                  <c:v>0.21</c:v>
                </c:pt>
                <c:pt idx="192">
                  <c:v>0.21</c:v>
                </c:pt>
                <c:pt idx="193">
                  <c:v>0.2</c:v>
                </c:pt>
                <c:pt idx="194">
                  <c:v>0.18</c:v>
                </c:pt>
                <c:pt idx="195">
                  <c:v>0.16</c:v>
                </c:pt>
                <c:pt idx="196">
                  <c:v>0.13</c:v>
                </c:pt>
                <c:pt idx="197">
                  <c:v>0.11</c:v>
                </c:pt>
                <c:pt idx="198">
                  <c:v>0.1</c:v>
                </c:pt>
                <c:pt idx="199">
                  <c:v>0.1</c:v>
                </c:pt>
                <c:pt idx="200">
                  <c:v>0.09</c:v>
                </c:pt>
                <c:pt idx="201">
                  <c:v>0.1</c:v>
                </c:pt>
                <c:pt idx="202">
                  <c:v>0.12</c:v>
                </c:pt>
                <c:pt idx="203">
                  <c:v>0.14000000000000001</c:v>
                </c:pt>
                <c:pt idx="204">
                  <c:v>0.17</c:v>
                </c:pt>
                <c:pt idx="205">
                  <c:v>0.21</c:v>
                </c:pt>
                <c:pt idx="206">
                  <c:v>0.23</c:v>
                </c:pt>
                <c:pt idx="207">
                  <c:v>0.25</c:v>
                </c:pt>
                <c:pt idx="208">
                  <c:v>0.27</c:v>
                </c:pt>
                <c:pt idx="209">
                  <c:v>0.28999999999999998</c:v>
                </c:pt>
                <c:pt idx="210">
                  <c:v>0.3</c:v>
                </c:pt>
                <c:pt idx="211">
                  <c:v>0.28999999999999998</c:v>
                </c:pt>
                <c:pt idx="212">
                  <c:v>0.28999999999999998</c:v>
                </c:pt>
                <c:pt idx="213">
                  <c:v>0.3</c:v>
                </c:pt>
                <c:pt idx="214">
                  <c:v>0.3</c:v>
                </c:pt>
                <c:pt idx="215">
                  <c:v>0.3</c:v>
                </c:pt>
                <c:pt idx="216">
                  <c:v>0.3</c:v>
                </c:pt>
                <c:pt idx="217">
                  <c:v>0.3</c:v>
                </c:pt>
                <c:pt idx="218">
                  <c:v>0.28999999999999998</c:v>
                </c:pt>
                <c:pt idx="219">
                  <c:v>0.28000000000000003</c:v>
                </c:pt>
                <c:pt idx="220">
                  <c:v>0.25</c:v>
                </c:pt>
                <c:pt idx="221">
                  <c:v>0.23</c:v>
                </c:pt>
                <c:pt idx="222">
                  <c:v>0.19</c:v>
                </c:pt>
                <c:pt idx="223">
                  <c:v>0.17</c:v>
                </c:pt>
                <c:pt idx="224">
                  <c:v>0.17</c:v>
                </c:pt>
                <c:pt idx="225">
                  <c:v>0.18</c:v>
                </c:pt>
                <c:pt idx="226">
                  <c:v>0.19</c:v>
                </c:pt>
                <c:pt idx="227">
                  <c:v>0.22</c:v>
                </c:pt>
                <c:pt idx="228">
                  <c:v>0.25</c:v>
                </c:pt>
                <c:pt idx="229">
                  <c:v>0.28000000000000003</c:v>
                </c:pt>
                <c:pt idx="230">
                  <c:v>0.32</c:v>
                </c:pt>
                <c:pt idx="231">
                  <c:v>0.37</c:v>
                </c:pt>
                <c:pt idx="232">
                  <c:v>0.41</c:v>
                </c:pt>
                <c:pt idx="233">
                  <c:v>0.45</c:v>
                </c:pt>
                <c:pt idx="234">
                  <c:v>0.48</c:v>
                </c:pt>
                <c:pt idx="235">
                  <c:v>0.55000000000000004</c:v>
                </c:pt>
                <c:pt idx="236">
                  <c:v>0.59</c:v>
                </c:pt>
                <c:pt idx="237">
                  <c:v>0.62</c:v>
                </c:pt>
                <c:pt idx="238">
                  <c:v>0.62</c:v>
                </c:pt>
                <c:pt idx="239">
                  <c:v>0.63</c:v>
                </c:pt>
                <c:pt idx="240">
                  <c:v>0.63</c:v>
                </c:pt>
                <c:pt idx="241">
                  <c:v>0.63</c:v>
                </c:pt>
                <c:pt idx="242">
                  <c:v>0.64</c:v>
                </c:pt>
                <c:pt idx="243">
                  <c:v>0.65</c:v>
                </c:pt>
                <c:pt idx="244">
                  <c:v>0.65</c:v>
                </c:pt>
                <c:pt idx="245">
                  <c:v>0.66</c:v>
                </c:pt>
                <c:pt idx="246">
                  <c:v>0.67</c:v>
                </c:pt>
                <c:pt idx="247">
                  <c:v>0.68</c:v>
                </c:pt>
                <c:pt idx="248">
                  <c:v>0.67</c:v>
                </c:pt>
                <c:pt idx="249">
                  <c:v>0.65</c:v>
                </c:pt>
                <c:pt idx="250">
                  <c:v>0.62</c:v>
                </c:pt>
                <c:pt idx="251">
                  <c:v>0.59</c:v>
                </c:pt>
                <c:pt idx="252">
                  <c:v>0.54</c:v>
                </c:pt>
                <c:pt idx="253">
                  <c:v>0.48</c:v>
                </c:pt>
                <c:pt idx="254">
                  <c:v>0.43</c:v>
                </c:pt>
                <c:pt idx="255">
                  <c:v>0.38</c:v>
                </c:pt>
                <c:pt idx="256">
                  <c:v>0.33</c:v>
                </c:pt>
                <c:pt idx="257">
                  <c:v>0.28999999999999998</c:v>
                </c:pt>
                <c:pt idx="258">
                  <c:v>0.25</c:v>
                </c:pt>
                <c:pt idx="259">
                  <c:v>0.21</c:v>
                </c:pt>
                <c:pt idx="260">
                  <c:v>0.18</c:v>
                </c:pt>
                <c:pt idx="261">
                  <c:v>0.16</c:v>
                </c:pt>
                <c:pt idx="262">
                  <c:v>0.15</c:v>
                </c:pt>
                <c:pt idx="263">
                  <c:v>0.15</c:v>
                </c:pt>
                <c:pt idx="264">
                  <c:v>0.16</c:v>
                </c:pt>
                <c:pt idx="265">
                  <c:v>0.17</c:v>
                </c:pt>
                <c:pt idx="266">
                  <c:v>0.18</c:v>
                </c:pt>
                <c:pt idx="267">
                  <c:v>0.2</c:v>
                </c:pt>
                <c:pt idx="268">
                  <c:v>0.23</c:v>
                </c:pt>
                <c:pt idx="269">
                  <c:v>0.25</c:v>
                </c:pt>
                <c:pt idx="270">
                  <c:v>0.27</c:v>
                </c:pt>
                <c:pt idx="271">
                  <c:v>0.28999999999999998</c:v>
                </c:pt>
                <c:pt idx="272">
                  <c:v>0.3</c:v>
                </c:pt>
                <c:pt idx="273">
                  <c:v>0.28999999999999998</c:v>
                </c:pt>
                <c:pt idx="274">
                  <c:v>0.27</c:v>
                </c:pt>
                <c:pt idx="275">
                  <c:v>0.24</c:v>
                </c:pt>
                <c:pt idx="276">
                  <c:v>0.21</c:v>
                </c:pt>
                <c:pt idx="277">
                  <c:v>0.17</c:v>
                </c:pt>
                <c:pt idx="278">
                  <c:v>0.14000000000000001</c:v>
                </c:pt>
                <c:pt idx="279">
                  <c:v>0.11</c:v>
                </c:pt>
                <c:pt idx="280">
                  <c:v>0.09</c:v>
                </c:pt>
                <c:pt idx="281">
                  <c:v>0.1</c:v>
                </c:pt>
                <c:pt idx="282">
                  <c:v>0.09</c:v>
                </c:pt>
                <c:pt idx="283">
                  <c:v>0.09</c:v>
                </c:pt>
                <c:pt idx="284">
                  <c:v>0.1</c:v>
                </c:pt>
                <c:pt idx="285">
                  <c:v>0.1</c:v>
                </c:pt>
                <c:pt idx="286">
                  <c:v>0.11</c:v>
                </c:pt>
                <c:pt idx="287">
                  <c:v>0.13</c:v>
                </c:pt>
                <c:pt idx="288">
                  <c:v>0.17</c:v>
                </c:pt>
                <c:pt idx="289">
                  <c:v>0.22</c:v>
                </c:pt>
                <c:pt idx="290">
                  <c:v>0.26</c:v>
                </c:pt>
                <c:pt idx="291">
                  <c:v>0.28000000000000003</c:v>
                </c:pt>
                <c:pt idx="292">
                  <c:v>0.3</c:v>
                </c:pt>
                <c:pt idx="293">
                  <c:v>0.3</c:v>
                </c:pt>
                <c:pt idx="294">
                  <c:v>0.3</c:v>
                </c:pt>
                <c:pt idx="295">
                  <c:v>0.3</c:v>
                </c:pt>
                <c:pt idx="296">
                  <c:v>0.3</c:v>
                </c:pt>
                <c:pt idx="297">
                  <c:v>0.28000000000000003</c:v>
                </c:pt>
                <c:pt idx="298">
                  <c:v>0.28000000000000003</c:v>
                </c:pt>
                <c:pt idx="299">
                  <c:v>0.27</c:v>
                </c:pt>
                <c:pt idx="300">
                  <c:v>0.27</c:v>
                </c:pt>
                <c:pt idx="301">
                  <c:v>0.27</c:v>
                </c:pt>
                <c:pt idx="302">
                  <c:v>0.26</c:v>
                </c:pt>
                <c:pt idx="303">
                  <c:v>0.25</c:v>
                </c:pt>
                <c:pt idx="304">
                  <c:v>0.25</c:v>
                </c:pt>
                <c:pt idx="305">
                  <c:v>0.24</c:v>
                </c:pt>
                <c:pt idx="306">
                  <c:v>0.23</c:v>
                </c:pt>
                <c:pt idx="307">
                  <c:v>0.22</c:v>
                </c:pt>
                <c:pt idx="308">
                  <c:v>0.22</c:v>
                </c:pt>
                <c:pt idx="309">
                  <c:v>0.21</c:v>
                </c:pt>
                <c:pt idx="310">
                  <c:v>0.22</c:v>
                </c:pt>
                <c:pt idx="311">
                  <c:v>0.23</c:v>
                </c:pt>
                <c:pt idx="312">
                  <c:v>0.21</c:v>
                </c:pt>
                <c:pt idx="313">
                  <c:v>0.2</c:v>
                </c:pt>
                <c:pt idx="314">
                  <c:v>0.19</c:v>
                </c:pt>
                <c:pt idx="315">
                  <c:v>0.19</c:v>
                </c:pt>
                <c:pt idx="316">
                  <c:v>0.19</c:v>
                </c:pt>
                <c:pt idx="317">
                  <c:v>0.19</c:v>
                </c:pt>
                <c:pt idx="318">
                  <c:v>0.19</c:v>
                </c:pt>
                <c:pt idx="319">
                  <c:v>0.21</c:v>
                </c:pt>
                <c:pt idx="320">
                  <c:v>0.23</c:v>
                </c:pt>
                <c:pt idx="321">
                  <c:v>0.27</c:v>
                </c:pt>
                <c:pt idx="322">
                  <c:v>0.3</c:v>
                </c:pt>
                <c:pt idx="323">
                  <c:v>0.32</c:v>
                </c:pt>
                <c:pt idx="324">
                  <c:v>0.33</c:v>
                </c:pt>
                <c:pt idx="325">
                  <c:v>0.32</c:v>
                </c:pt>
                <c:pt idx="326">
                  <c:v>0.31</c:v>
                </c:pt>
                <c:pt idx="327">
                  <c:v>0.28999999999999998</c:v>
                </c:pt>
                <c:pt idx="328">
                  <c:v>0.26</c:v>
                </c:pt>
                <c:pt idx="329">
                  <c:v>0.24</c:v>
                </c:pt>
                <c:pt idx="330">
                  <c:v>0.22</c:v>
                </c:pt>
                <c:pt idx="331">
                  <c:v>0.22</c:v>
                </c:pt>
                <c:pt idx="332">
                  <c:v>0.22</c:v>
                </c:pt>
                <c:pt idx="333">
                  <c:v>0.21</c:v>
                </c:pt>
                <c:pt idx="334">
                  <c:v>0.21</c:v>
                </c:pt>
                <c:pt idx="335">
                  <c:v>0.21</c:v>
                </c:pt>
                <c:pt idx="336">
                  <c:v>0.21</c:v>
                </c:pt>
                <c:pt idx="337">
                  <c:v>0.22</c:v>
                </c:pt>
                <c:pt idx="338">
                  <c:v>0.23</c:v>
                </c:pt>
                <c:pt idx="339">
                  <c:v>0.24</c:v>
                </c:pt>
                <c:pt idx="340">
                  <c:v>0.28000000000000003</c:v>
                </c:pt>
                <c:pt idx="341">
                  <c:v>0.32</c:v>
                </c:pt>
                <c:pt idx="342">
                  <c:v>0.37</c:v>
                </c:pt>
                <c:pt idx="343">
                  <c:v>0.42</c:v>
                </c:pt>
                <c:pt idx="344">
                  <c:v>0.48</c:v>
                </c:pt>
                <c:pt idx="345">
                  <c:v>0.55000000000000004</c:v>
                </c:pt>
                <c:pt idx="346">
                  <c:v>0.61</c:v>
                </c:pt>
                <c:pt idx="347">
                  <c:v>0.66</c:v>
                </c:pt>
                <c:pt idx="348">
                  <c:v>0.7</c:v>
                </c:pt>
                <c:pt idx="349">
                  <c:v>0.73</c:v>
                </c:pt>
                <c:pt idx="350">
                  <c:v>0.76</c:v>
                </c:pt>
                <c:pt idx="351">
                  <c:v>0.78</c:v>
                </c:pt>
                <c:pt idx="352">
                  <c:v>0.79</c:v>
                </c:pt>
                <c:pt idx="353">
                  <c:v>0.8</c:v>
                </c:pt>
                <c:pt idx="354">
                  <c:v>0.81</c:v>
                </c:pt>
                <c:pt idx="355">
                  <c:v>0.81</c:v>
                </c:pt>
                <c:pt idx="356">
                  <c:v>0.8</c:v>
                </c:pt>
                <c:pt idx="357">
                  <c:v>0.77</c:v>
                </c:pt>
                <c:pt idx="358">
                  <c:v>0.73</c:v>
                </c:pt>
                <c:pt idx="359">
                  <c:v>0.69</c:v>
                </c:pt>
                <c:pt idx="360">
                  <c:v>0.65</c:v>
                </c:pt>
                <c:pt idx="361">
                  <c:v>0.6</c:v>
                </c:pt>
                <c:pt idx="362">
                  <c:v>0.55000000000000004</c:v>
                </c:pt>
                <c:pt idx="363">
                  <c:v>0.47</c:v>
                </c:pt>
                <c:pt idx="364">
                  <c:v>0.44</c:v>
                </c:pt>
                <c:pt idx="365">
                  <c:v>0.4</c:v>
                </c:pt>
                <c:pt idx="366">
                  <c:v>0.37</c:v>
                </c:pt>
                <c:pt idx="367">
                  <c:v>0.33</c:v>
                </c:pt>
                <c:pt idx="368">
                  <c:v>0.28999999999999998</c:v>
                </c:pt>
                <c:pt idx="369">
                  <c:v>0.24</c:v>
                </c:pt>
                <c:pt idx="370">
                  <c:v>0.2</c:v>
                </c:pt>
                <c:pt idx="371">
                  <c:v>0.17</c:v>
                </c:pt>
                <c:pt idx="372">
                  <c:v>0.14000000000000001</c:v>
                </c:pt>
                <c:pt idx="373">
                  <c:v>0.11</c:v>
                </c:pt>
                <c:pt idx="374">
                  <c:v>0.09</c:v>
                </c:pt>
                <c:pt idx="375">
                  <c:v>0.09</c:v>
                </c:pt>
                <c:pt idx="376">
                  <c:v>0.11</c:v>
                </c:pt>
                <c:pt idx="377">
                  <c:v>0.12</c:v>
                </c:pt>
                <c:pt idx="378">
                  <c:v>0.15</c:v>
                </c:pt>
                <c:pt idx="379">
                  <c:v>0.17</c:v>
                </c:pt>
                <c:pt idx="380">
                  <c:v>0.2</c:v>
                </c:pt>
                <c:pt idx="381">
                  <c:v>0.22</c:v>
                </c:pt>
                <c:pt idx="382">
                  <c:v>0.23</c:v>
                </c:pt>
                <c:pt idx="383">
                  <c:v>0.24</c:v>
                </c:pt>
                <c:pt idx="384">
                  <c:v>0.24</c:v>
                </c:pt>
                <c:pt idx="385">
                  <c:v>0.23</c:v>
                </c:pt>
                <c:pt idx="386">
                  <c:v>0.23</c:v>
                </c:pt>
                <c:pt idx="387">
                  <c:v>0.23</c:v>
                </c:pt>
                <c:pt idx="388">
                  <c:v>0.23</c:v>
                </c:pt>
                <c:pt idx="389">
                  <c:v>0.23</c:v>
                </c:pt>
                <c:pt idx="390">
                  <c:v>0.24</c:v>
                </c:pt>
                <c:pt idx="391">
                  <c:v>0.24</c:v>
                </c:pt>
                <c:pt idx="392">
                  <c:v>0.25</c:v>
                </c:pt>
                <c:pt idx="393">
                  <c:v>0.25</c:v>
                </c:pt>
                <c:pt idx="394">
                  <c:v>0.25</c:v>
                </c:pt>
                <c:pt idx="395">
                  <c:v>0.25</c:v>
                </c:pt>
                <c:pt idx="396">
                  <c:v>0.25</c:v>
                </c:pt>
                <c:pt idx="397">
                  <c:v>0.25</c:v>
                </c:pt>
                <c:pt idx="398">
                  <c:v>0.25</c:v>
                </c:pt>
                <c:pt idx="399">
                  <c:v>0.26</c:v>
                </c:pt>
                <c:pt idx="400">
                  <c:v>0.26</c:v>
                </c:pt>
                <c:pt idx="401">
                  <c:v>0.26</c:v>
                </c:pt>
                <c:pt idx="402">
                  <c:v>0.25</c:v>
                </c:pt>
                <c:pt idx="403">
                  <c:v>0.24</c:v>
                </c:pt>
                <c:pt idx="404">
                  <c:v>0.24</c:v>
                </c:pt>
                <c:pt idx="405">
                  <c:v>0.22</c:v>
                </c:pt>
                <c:pt idx="406">
                  <c:v>0.2</c:v>
                </c:pt>
                <c:pt idx="407">
                  <c:v>0.19</c:v>
                </c:pt>
                <c:pt idx="408">
                  <c:v>0.19</c:v>
                </c:pt>
                <c:pt idx="409">
                  <c:v>0.19</c:v>
                </c:pt>
                <c:pt idx="410">
                  <c:v>0.19</c:v>
                </c:pt>
                <c:pt idx="411">
                  <c:v>0.21</c:v>
                </c:pt>
                <c:pt idx="412">
                  <c:v>0.22</c:v>
                </c:pt>
                <c:pt idx="413">
                  <c:v>0.25</c:v>
                </c:pt>
                <c:pt idx="414">
                  <c:v>0.27</c:v>
                </c:pt>
                <c:pt idx="415">
                  <c:v>0.28999999999999998</c:v>
                </c:pt>
                <c:pt idx="416">
                  <c:v>0.31</c:v>
                </c:pt>
                <c:pt idx="417">
                  <c:v>0.33</c:v>
                </c:pt>
                <c:pt idx="418">
                  <c:v>0.34</c:v>
                </c:pt>
                <c:pt idx="419">
                  <c:v>0.35</c:v>
                </c:pt>
                <c:pt idx="420">
                  <c:v>0.36</c:v>
                </c:pt>
                <c:pt idx="421">
                  <c:v>0.36</c:v>
                </c:pt>
                <c:pt idx="422">
                  <c:v>0.36</c:v>
                </c:pt>
                <c:pt idx="423">
                  <c:v>0.36</c:v>
                </c:pt>
                <c:pt idx="424">
                  <c:v>0.36</c:v>
                </c:pt>
                <c:pt idx="425">
                  <c:v>0.36</c:v>
                </c:pt>
                <c:pt idx="426">
                  <c:v>0.34</c:v>
                </c:pt>
                <c:pt idx="427">
                  <c:v>0.32</c:v>
                </c:pt>
                <c:pt idx="428">
                  <c:v>0.28999999999999998</c:v>
                </c:pt>
                <c:pt idx="429">
                  <c:v>0.26</c:v>
                </c:pt>
                <c:pt idx="430">
                  <c:v>0.23</c:v>
                </c:pt>
                <c:pt idx="431">
                  <c:v>0.21</c:v>
                </c:pt>
                <c:pt idx="432">
                  <c:v>0.17</c:v>
                </c:pt>
                <c:pt idx="433">
                  <c:v>0.16</c:v>
                </c:pt>
                <c:pt idx="434">
                  <c:v>0.16</c:v>
                </c:pt>
                <c:pt idx="435">
                  <c:v>0.17</c:v>
                </c:pt>
                <c:pt idx="436">
                  <c:v>0.19</c:v>
                </c:pt>
                <c:pt idx="437">
                  <c:v>0.23</c:v>
                </c:pt>
                <c:pt idx="438">
                  <c:v>0.26</c:v>
                </c:pt>
                <c:pt idx="439">
                  <c:v>0.28999999999999998</c:v>
                </c:pt>
                <c:pt idx="440">
                  <c:v>0.31</c:v>
                </c:pt>
                <c:pt idx="441">
                  <c:v>0.34</c:v>
                </c:pt>
                <c:pt idx="442">
                  <c:v>0.35</c:v>
                </c:pt>
                <c:pt idx="443">
                  <c:v>0.36</c:v>
                </c:pt>
                <c:pt idx="444">
                  <c:v>0.36</c:v>
                </c:pt>
                <c:pt idx="445">
                  <c:v>0.36</c:v>
                </c:pt>
                <c:pt idx="446">
                  <c:v>0.35</c:v>
                </c:pt>
                <c:pt idx="447">
                  <c:v>0.33</c:v>
                </c:pt>
                <c:pt idx="448">
                  <c:v>0.31</c:v>
                </c:pt>
                <c:pt idx="449">
                  <c:v>0.3</c:v>
                </c:pt>
                <c:pt idx="450">
                  <c:v>0.27</c:v>
                </c:pt>
                <c:pt idx="451">
                  <c:v>0.25</c:v>
                </c:pt>
                <c:pt idx="452">
                  <c:v>0.22</c:v>
                </c:pt>
                <c:pt idx="453">
                  <c:v>0.19</c:v>
                </c:pt>
                <c:pt idx="454">
                  <c:v>0.17</c:v>
                </c:pt>
                <c:pt idx="455">
                  <c:v>0.15</c:v>
                </c:pt>
                <c:pt idx="456">
                  <c:v>0.13</c:v>
                </c:pt>
                <c:pt idx="457">
                  <c:v>0.12</c:v>
                </c:pt>
                <c:pt idx="458">
                  <c:v>0.1</c:v>
                </c:pt>
                <c:pt idx="459">
                  <c:v>0.1</c:v>
                </c:pt>
                <c:pt idx="460">
                  <c:v>0.1</c:v>
                </c:pt>
                <c:pt idx="461">
                  <c:v>0.1</c:v>
                </c:pt>
                <c:pt idx="462">
                  <c:v>0.1</c:v>
                </c:pt>
                <c:pt idx="463">
                  <c:v>0.14000000000000001</c:v>
                </c:pt>
                <c:pt idx="464">
                  <c:v>0.19</c:v>
                </c:pt>
                <c:pt idx="465">
                  <c:v>0.26</c:v>
                </c:pt>
                <c:pt idx="466">
                  <c:v>0.33</c:v>
                </c:pt>
                <c:pt idx="467">
                  <c:v>0.42</c:v>
                </c:pt>
                <c:pt idx="468">
                  <c:v>0.51</c:v>
                </c:pt>
                <c:pt idx="469">
                  <c:v>0.6</c:v>
                </c:pt>
                <c:pt idx="470">
                  <c:v>0.66</c:v>
                </c:pt>
                <c:pt idx="471">
                  <c:v>0.71</c:v>
                </c:pt>
                <c:pt idx="472">
                  <c:v>0.75</c:v>
                </c:pt>
                <c:pt idx="473">
                  <c:v>0.79</c:v>
                </c:pt>
                <c:pt idx="474">
                  <c:v>0.81</c:v>
                </c:pt>
                <c:pt idx="475">
                  <c:v>0.83</c:v>
                </c:pt>
                <c:pt idx="476">
                  <c:v>0.83</c:v>
                </c:pt>
                <c:pt idx="477">
                  <c:v>0.83</c:v>
                </c:pt>
                <c:pt idx="478">
                  <c:v>0.82</c:v>
                </c:pt>
                <c:pt idx="479">
                  <c:v>0.82</c:v>
                </c:pt>
                <c:pt idx="480">
                  <c:v>0.81</c:v>
                </c:pt>
                <c:pt idx="481">
                  <c:v>0.8</c:v>
                </c:pt>
                <c:pt idx="482">
                  <c:v>0.8</c:v>
                </c:pt>
                <c:pt idx="483">
                  <c:v>0.79</c:v>
                </c:pt>
                <c:pt idx="484">
                  <c:v>0.78</c:v>
                </c:pt>
                <c:pt idx="485">
                  <c:v>0.78</c:v>
                </c:pt>
                <c:pt idx="486">
                  <c:v>0.77</c:v>
                </c:pt>
                <c:pt idx="487">
                  <c:v>0.77</c:v>
                </c:pt>
                <c:pt idx="488">
                  <c:v>0.75</c:v>
                </c:pt>
                <c:pt idx="489">
                  <c:v>0.74</c:v>
                </c:pt>
                <c:pt idx="490">
                  <c:v>0.72</c:v>
                </c:pt>
                <c:pt idx="491">
                  <c:v>0.7</c:v>
                </c:pt>
                <c:pt idx="492">
                  <c:v>0.69</c:v>
                </c:pt>
                <c:pt idx="493">
                  <c:v>0.69</c:v>
                </c:pt>
                <c:pt idx="494">
                  <c:v>0.68</c:v>
                </c:pt>
                <c:pt idx="495">
                  <c:v>0.67</c:v>
                </c:pt>
                <c:pt idx="496">
                  <c:v>0.64</c:v>
                </c:pt>
                <c:pt idx="497">
                  <c:v>0.6</c:v>
                </c:pt>
                <c:pt idx="498">
                  <c:v>0.55000000000000004</c:v>
                </c:pt>
                <c:pt idx="499">
                  <c:v>0.48</c:v>
                </c:pt>
                <c:pt idx="500">
                  <c:v>0.44</c:v>
                </c:pt>
                <c:pt idx="501">
                  <c:v>0.39</c:v>
                </c:pt>
                <c:pt idx="502">
                  <c:v>0.33</c:v>
                </c:pt>
                <c:pt idx="503">
                  <c:v>0.28000000000000003</c:v>
                </c:pt>
                <c:pt idx="504">
                  <c:v>0.25</c:v>
                </c:pt>
                <c:pt idx="505">
                  <c:v>0.22</c:v>
                </c:pt>
                <c:pt idx="506">
                  <c:v>0.21</c:v>
                </c:pt>
                <c:pt idx="507">
                  <c:v>0.21</c:v>
                </c:pt>
                <c:pt idx="508">
                  <c:v>0.21</c:v>
                </c:pt>
                <c:pt idx="509">
                  <c:v>0.23</c:v>
                </c:pt>
                <c:pt idx="510">
                  <c:v>0.25</c:v>
                </c:pt>
                <c:pt idx="511">
                  <c:v>0.27</c:v>
                </c:pt>
                <c:pt idx="512">
                  <c:v>0.28999999999999998</c:v>
                </c:pt>
                <c:pt idx="513">
                  <c:v>0.28999999999999998</c:v>
                </c:pt>
                <c:pt idx="514">
                  <c:v>0.3</c:v>
                </c:pt>
                <c:pt idx="515">
                  <c:v>0.3</c:v>
                </c:pt>
                <c:pt idx="516">
                  <c:v>0.31</c:v>
                </c:pt>
                <c:pt idx="517">
                  <c:v>0.33</c:v>
                </c:pt>
                <c:pt idx="518">
                  <c:v>0.37</c:v>
                </c:pt>
                <c:pt idx="519">
                  <c:v>0.42</c:v>
                </c:pt>
                <c:pt idx="520">
                  <c:v>0.47</c:v>
                </c:pt>
                <c:pt idx="521">
                  <c:v>0.55000000000000004</c:v>
                </c:pt>
                <c:pt idx="522">
                  <c:v>0.62</c:v>
                </c:pt>
                <c:pt idx="523">
                  <c:v>0.69</c:v>
                </c:pt>
                <c:pt idx="524">
                  <c:v>0.76</c:v>
                </c:pt>
                <c:pt idx="525">
                  <c:v>0.82</c:v>
                </c:pt>
                <c:pt idx="526">
                  <c:v>0.88</c:v>
                </c:pt>
                <c:pt idx="527">
                  <c:v>0.9</c:v>
                </c:pt>
                <c:pt idx="528">
                  <c:v>0.91</c:v>
                </c:pt>
                <c:pt idx="529">
                  <c:v>0.92</c:v>
                </c:pt>
                <c:pt idx="530">
                  <c:v>0.93</c:v>
                </c:pt>
                <c:pt idx="531">
                  <c:v>0.93</c:v>
                </c:pt>
                <c:pt idx="532">
                  <c:v>0.94</c:v>
                </c:pt>
                <c:pt idx="533">
                  <c:v>0.93</c:v>
                </c:pt>
                <c:pt idx="534">
                  <c:v>0.93</c:v>
                </c:pt>
                <c:pt idx="535">
                  <c:v>0.92</c:v>
                </c:pt>
                <c:pt idx="536">
                  <c:v>0.92</c:v>
                </c:pt>
                <c:pt idx="537">
                  <c:v>0.92</c:v>
                </c:pt>
                <c:pt idx="538">
                  <c:v>0.91</c:v>
                </c:pt>
                <c:pt idx="539">
                  <c:v>0.91</c:v>
                </c:pt>
                <c:pt idx="540">
                  <c:v>0.9</c:v>
                </c:pt>
                <c:pt idx="541">
                  <c:v>0.9</c:v>
                </c:pt>
                <c:pt idx="542">
                  <c:v>0.87</c:v>
                </c:pt>
                <c:pt idx="543">
                  <c:v>0.82</c:v>
                </c:pt>
                <c:pt idx="544">
                  <c:v>0.77</c:v>
                </c:pt>
                <c:pt idx="545">
                  <c:v>0.72</c:v>
                </c:pt>
                <c:pt idx="546">
                  <c:v>0.67</c:v>
                </c:pt>
                <c:pt idx="547">
                  <c:v>0.61</c:v>
                </c:pt>
                <c:pt idx="548">
                  <c:v>0.56000000000000005</c:v>
                </c:pt>
                <c:pt idx="549">
                  <c:v>0.52</c:v>
                </c:pt>
                <c:pt idx="550">
                  <c:v>0.47</c:v>
                </c:pt>
                <c:pt idx="551">
                  <c:v>0.43</c:v>
                </c:pt>
                <c:pt idx="552">
                  <c:v>0.4</c:v>
                </c:pt>
                <c:pt idx="553">
                  <c:v>0.39</c:v>
                </c:pt>
                <c:pt idx="554">
                  <c:v>0.37</c:v>
                </c:pt>
                <c:pt idx="555">
                  <c:v>0.36</c:v>
                </c:pt>
                <c:pt idx="556">
                  <c:v>0.36</c:v>
                </c:pt>
                <c:pt idx="557">
                  <c:v>0.37</c:v>
                </c:pt>
                <c:pt idx="558">
                  <c:v>0.39</c:v>
                </c:pt>
                <c:pt idx="559">
                  <c:v>0.41</c:v>
                </c:pt>
                <c:pt idx="560">
                  <c:v>0.46</c:v>
                </c:pt>
                <c:pt idx="561">
                  <c:v>0.53</c:v>
                </c:pt>
                <c:pt idx="562">
                  <c:v>0.59</c:v>
                </c:pt>
                <c:pt idx="563">
                  <c:v>0.63</c:v>
                </c:pt>
                <c:pt idx="564">
                  <c:v>0.68</c:v>
                </c:pt>
                <c:pt idx="565">
                  <c:v>0.71</c:v>
                </c:pt>
                <c:pt idx="566">
                  <c:v>0.75</c:v>
                </c:pt>
                <c:pt idx="567">
                  <c:v>0.77</c:v>
                </c:pt>
                <c:pt idx="568">
                  <c:v>0.8</c:v>
                </c:pt>
                <c:pt idx="569">
                  <c:v>0.83</c:v>
                </c:pt>
                <c:pt idx="570">
                  <c:v>0.85</c:v>
                </c:pt>
                <c:pt idx="571">
                  <c:v>0.86</c:v>
                </c:pt>
                <c:pt idx="572">
                  <c:v>0.89</c:v>
                </c:pt>
                <c:pt idx="573">
                  <c:v>0.9</c:v>
                </c:pt>
                <c:pt idx="574">
                  <c:v>0.91</c:v>
                </c:pt>
                <c:pt idx="575">
                  <c:v>0.91</c:v>
                </c:pt>
                <c:pt idx="576">
                  <c:v>0.92</c:v>
                </c:pt>
                <c:pt idx="577">
                  <c:v>0.92</c:v>
                </c:pt>
                <c:pt idx="578">
                  <c:v>0.92</c:v>
                </c:pt>
                <c:pt idx="579">
                  <c:v>0.92</c:v>
                </c:pt>
                <c:pt idx="580">
                  <c:v>0.92</c:v>
                </c:pt>
                <c:pt idx="581">
                  <c:v>0.91</c:v>
                </c:pt>
                <c:pt idx="582">
                  <c:v>0.91</c:v>
                </c:pt>
                <c:pt idx="583">
                  <c:v>0.9</c:v>
                </c:pt>
                <c:pt idx="584">
                  <c:v>0.89</c:v>
                </c:pt>
                <c:pt idx="585">
                  <c:v>0.87</c:v>
                </c:pt>
                <c:pt idx="586">
                  <c:v>0.84</c:v>
                </c:pt>
                <c:pt idx="587">
                  <c:v>0.89</c:v>
                </c:pt>
                <c:pt idx="588">
                  <c:v>0.88</c:v>
                </c:pt>
                <c:pt idx="589">
                  <c:v>0.78</c:v>
                </c:pt>
                <c:pt idx="590">
                  <c:v>0.9</c:v>
                </c:pt>
                <c:pt idx="591">
                  <c:v>0.91</c:v>
                </c:pt>
                <c:pt idx="592">
                  <c:v>0.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D0F-244A-8A21-C7428CB7F459}"/>
            </c:ext>
          </c:extLst>
        </c:ser>
        <c:ser>
          <c:idx val="1"/>
          <c:order val="1"/>
          <c:tx>
            <c:v>IUPred</c:v>
          </c:tx>
          <c:spPr>
            <a:ln w="9525" cap="rnd">
              <a:solidFill>
                <a:srgbClr val="D82042"/>
              </a:solidFill>
              <a:round/>
            </a:ln>
            <a:effectLst/>
          </c:spPr>
          <c:marker>
            <c:symbol val="none"/>
          </c:marker>
          <c:yVal>
            <c:numRef>
              <c:f>Sheet1!$C$2:$C$594</c:f>
              <c:numCache>
                <c:formatCode>General</c:formatCode>
                <c:ptCount val="593"/>
                <c:pt idx="0">
                  <c:v>0.94230000000000003</c:v>
                </c:pt>
                <c:pt idx="1">
                  <c:v>0.92079999999999995</c:v>
                </c:pt>
                <c:pt idx="2">
                  <c:v>0.89449999999999996</c:v>
                </c:pt>
                <c:pt idx="3">
                  <c:v>0.84240000000000004</c:v>
                </c:pt>
                <c:pt idx="4">
                  <c:v>0.80740000000000001</c:v>
                </c:pt>
                <c:pt idx="5">
                  <c:v>0.76880000000000004</c:v>
                </c:pt>
                <c:pt idx="6">
                  <c:v>0.73419999999999996</c:v>
                </c:pt>
                <c:pt idx="7">
                  <c:v>0.64419999999999999</c:v>
                </c:pt>
                <c:pt idx="8">
                  <c:v>0.57620000000000005</c:v>
                </c:pt>
                <c:pt idx="9">
                  <c:v>0.53310000000000002</c:v>
                </c:pt>
                <c:pt idx="10">
                  <c:v>0.49180000000000001</c:v>
                </c:pt>
                <c:pt idx="11">
                  <c:v>0.51729999999999998</c:v>
                </c:pt>
                <c:pt idx="12">
                  <c:v>0.55489999999999995</c:v>
                </c:pt>
                <c:pt idx="13">
                  <c:v>0.48249999999999998</c:v>
                </c:pt>
                <c:pt idx="14">
                  <c:v>0.42030000000000001</c:v>
                </c:pt>
                <c:pt idx="15">
                  <c:v>0.32629999999999998</c:v>
                </c:pt>
                <c:pt idx="16">
                  <c:v>0.32629999999999998</c:v>
                </c:pt>
                <c:pt idx="17">
                  <c:v>0.33589999999999998</c:v>
                </c:pt>
                <c:pt idx="18">
                  <c:v>0.31840000000000002</c:v>
                </c:pt>
                <c:pt idx="19">
                  <c:v>0.29630000000000001</c:v>
                </c:pt>
                <c:pt idx="20">
                  <c:v>0.31459999999999999</c:v>
                </c:pt>
                <c:pt idx="21">
                  <c:v>0.33589999999999998</c:v>
                </c:pt>
                <c:pt idx="22">
                  <c:v>0.34560000000000002</c:v>
                </c:pt>
                <c:pt idx="23">
                  <c:v>0.27860000000000001</c:v>
                </c:pt>
                <c:pt idx="24">
                  <c:v>0.2432</c:v>
                </c:pt>
                <c:pt idx="25">
                  <c:v>0.17660000000000001</c:v>
                </c:pt>
                <c:pt idx="26">
                  <c:v>0.18049999999999999</c:v>
                </c:pt>
                <c:pt idx="27">
                  <c:v>0.124</c:v>
                </c:pt>
                <c:pt idx="28">
                  <c:v>0.17319999999999999</c:v>
                </c:pt>
                <c:pt idx="29">
                  <c:v>0.19980000000000001</c:v>
                </c:pt>
                <c:pt idx="30">
                  <c:v>0.17319999999999999</c:v>
                </c:pt>
                <c:pt idx="31">
                  <c:v>0.17660000000000001</c:v>
                </c:pt>
                <c:pt idx="32">
                  <c:v>0.1041</c:v>
                </c:pt>
                <c:pt idx="33">
                  <c:v>9.6500000000000002E-2</c:v>
                </c:pt>
                <c:pt idx="34">
                  <c:v>9.0899999999999995E-2</c:v>
                </c:pt>
                <c:pt idx="35">
                  <c:v>0.124</c:v>
                </c:pt>
                <c:pt idx="36">
                  <c:v>0.18440000000000001</c:v>
                </c:pt>
                <c:pt idx="37">
                  <c:v>0.11169999999999999</c:v>
                </c:pt>
                <c:pt idx="38">
                  <c:v>8.5800000000000001E-2</c:v>
                </c:pt>
                <c:pt idx="39">
                  <c:v>4.7800000000000002E-2</c:v>
                </c:pt>
                <c:pt idx="40">
                  <c:v>5.1400000000000001E-2</c:v>
                </c:pt>
                <c:pt idx="41">
                  <c:v>3.7600000000000001E-2</c:v>
                </c:pt>
                <c:pt idx="42">
                  <c:v>3.6299999999999999E-2</c:v>
                </c:pt>
                <c:pt idx="43">
                  <c:v>3.3599999999999998E-2</c:v>
                </c:pt>
                <c:pt idx="44">
                  <c:v>5.1400000000000001E-2</c:v>
                </c:pt>
                <c:pt idx="45">
                  <c:v>4.9000000000000002E-2</c:v>
                </c:pt>
                <c:pt idx="46">
                  <c:v>4.6399999999999997E-2</c:v>
                </c:pt>
                <c:pt idx="47">
                  <c:v>4.2500000000000003E-2</c:v>
                </c:pt>
                <c:pt idx="48">
                  <c:v>6.4299999999999996E-2</c:v>
                </c:pt>
                <c:pt idx="49">
                  <c:v>3.8699999999999998E-2</c:v>
                </c:pt>
                <c:pt idx="50">
                  <c:v>2.2599999999999999E-2</c:v>
                </c:pt>
                <c:pt idx="51">
                  <c:v>2.4500000000000001E-2</c:v>
                </c:pt>
                <c:pt idx="52">
                  <c:v>2.52E-2</c:v>
                </c:pt>
                <c:pt idx="53">
                  <c:v>4.6399999999999997E-2</c:v>
                </c:pt>
                <c:pt idx="54">
                  <c:v>4.6399999999999997E-2</c:v>
                </c:pt>
                <c:pt idx="55">
                  <c:v>7.8899999999999998E-2</c:v>
                </c:pt>
                <c:pt idx="56">
                  <c:v>7.8899999999999998E-2</c:v>
                </c:pt>
                <c:pt idx="57">
                  <c:v>8.3199999999999996E-2</c:v>
                </c:pt>
                <c:pt idx="58">
                  <c:v>9.9099999999999994E-2</c:v>
                </c:pt>
                <c:pt idx="59">
                  <c:v>0.115</c:v>
                </c:pt>
                <c:pt idx="60">
                  <c:v>0.17660000000000001</c:v>
                </c:pt>
                <c:pt idx="61">
                  <c:v>0.16350000000000001</c:v>
                </c:pt>
                <c:pt idx="62">
                  <c:v>0.18779999999999999</c:v>
                </c:pt>
                <c:pt idx="63">
                  <c:v>0.12659999999999999</c:v>
                </c:pt>
                <c:pt idx="64">
                  <c:v>0.12659999999999999</c:v>
                </c:pt>
                <c:pt idx="65">
                  <c:v>0.12920000000000001</c:v>
                </c:pt>
                <c:pt idx="66">
                  <c:v>0.12659999999999999</c:v>
                </c:pt>
                <c:pt idx="67">
                  <c:v>0.2122</c:v>
                </c:pt>
                <c:pt idx="68">
                  <c:v>0.2167</c:v>
                </c:pt>
                <c:pt idx="69">
                  <c:v>0.22090000000000001</c:v>
                </c:pt>
                <c:pt idx="70">
                  <c:v>0.33110000000000001</c:v>
                </c:pt>
                <c:pt idx="71">
                  <c:v>0.41489999999999999</c:v>
                </c:pt>
                <c:pt idx="72">
                  <c:v>0.36680000000000001</c:v>
                </c:pt>
                <c:pt idx="73">
                  <c:v>0.27</c:v>
                </c:pt>
                <c:pt idx="74">
                  <c:v>0.28649999999999998</c:v>
                </c:pt>
                <c:pt idx="75">
                  <c:v>0.27860000000000001</c:v>
                </c:pt>
                <c:pt idx="76">
                  <c:v>0.23849999999999999</c:v>
                </c:pt>
                <c:pt idx="77">
                  <c:v>0.20799999999999999</c:v>
                </c:pt>
                <c:pt idx="78">
                  <c:v>0.1958</c:v>
                </c:pt>
                <c:pt idx="79">
                  <c:v>0.18049999999999999</c:v>
                </c:pt>
                <c:pt idx="80">
                  <c:v>0.115</c:v>
                </c:pt>
                <c:pt idx="81">
                  <c:v>7.0099999999999996E-2</c:v>
                </c:pt>
                <c:pt idx="82">
                  <c:v>0.11169999999999999</c:v>
                </c:pt>
                <c:pt idx="83">
                  <c:v>7.0099999999999996E-2</c:v>
                </c:pt>
                <c:pt idx="84">
                  <c:v>0.115</c:v>
                </c:pt>
                <c:pt idx="85">
                  <c:v>6.4299999999999996E-2</c:v>
                </c:pt>
                <c:pt idx="86">
                  <c:v>6.7699999999999996E-2</c:v>
                </c:pt>
                <c:pt idx="87">
                  <c:v>6.7699999999999996E-2</c:v>
                </c:pt>
                <c:pt idx="88">
                  <c:v>5.4199999999999998E-2</c:v>
                </c:pt>
                <c:pt idx="89">
                  <c:v>3.6299999999999999E-2</c:v>
                </c:pt>
                <c:pt idx="90">
                  <c:v>3.7600000000000001E-2</c:v>
                </c:pt>
                <c:pt idx="91">
                  <c:v>2.9700000000000001E-2</c:v>
                </c:pt>
                <c:pt idx="92">
                  <c:v>1.67E-2</c:v>
                </c:pt>
                <c:pt idx="93">
                  <c:v>2.2599999999999999E-2</c:v>
                </c:pt>
                <c:pt idx="94">
                  <c:v>3.1600000000000003E-2</c:v>
                </c:pt>
                <c:pt idx="95">
                  <c:v>1.5699999999999999E-2</c:v>
                </c:pt>
                <c:pt idx="96">
                  <c:v>1.5699999999999999E-2</c:v>
                </c:pt>
                <c:pt idx="97">
                  <c:v>8.3000000000000001E-3</c:v>
                </c:pt>
                <c:pt idx="98">
                  <c:v>8.3000000000000001E-3</c:v>
                </c:pt>
                <c:pt idx="99">
                  <c:v>7.0000000000000001E-3</c:v>
                </c:pt>
                <c:pt idx="100">
                  <c:v>1.37E-2</c:v>
                </c:pt>
                <c:pt idx="101">
                  <c:v>1.24E-2</c:v>
                </c:pt>
                <c:pt idx="102">
                  <c:v>1.24E-2</c:v>
                </c:pt>
                <c:pt idx="103">
                  <c:v>1.24E-2</c:v>
                </c:pt>
                <c:pt idx="104">
                  <c:v>1.5699999999999999E-2</c:v>
                </c:pt>
                <c:pt idx="105">
                  <c:v>1.4999999999999999E-2</c:v>
                </c:pt>
                <c:pt idx="106">
                  <c:v>3.27E-2</c:v>
                </c:pt>
                <c:pt idx="107">
                  <c:v>2.86E-2</c:v>
                </c:pt>
                <c:pt idx="108">
                  <c:v>2.7900000000000001E-2</c:v>
                </c:pt>
                <c:pt idx="109">
                  <c:v>1.41E-2</c:v>
                </c:pt>
                <c:pt idx="110">
                  <c:v>2.6800000000000001E-2</c:v>
                </c:pt>
                <c:pt idx="111">
                  <c:v>2.5899999999999999E-2</c:v>
                </c:pt>
                <c:pt idx="112">
                  <c:v>2.7400000000000001E-2</c:v>
                </c:pt>
                <c:pt idx="113">
                  <c:v>2.3099999999999999E-2</c:v>
                </c:pt>
                <c:pt idx="114">
                  <c:v>2.2599999999999999E-2</c:v>
                </c:pt>
                <c:pt idx="115">
                  <c:v>2.7900000000000001E-2</c:v>
                </c:pt>
                <c:pt idx="116">
                  <c:v>4.6399999999999997E-2</c:v>
                </c:pt>
                <c:pt idx="117">
                  <c:v>4.6399999999999997E-2</c:v>
                </c:pt>
                <c:pt idx="118">
                  <c:v>9.9099999999999994E-2</c:v>
                </c:pt>
                <c:pt idx="119">
                  <c:v>0.12659999999999999</c:v>
                </c:pt>
                <c:pt idx="120">
                  <c:v>8.8400000000000006E-2</c:v>
                </c:pt>
                <c:pt idx="121">
                  <c:v>4.6399999999999997E-2</c:v>
                </c:pt>
                <c:pt idx="122">
                  <c:v>8.5800000000000001E-2</c:v>
                </c:pt>
                <c:pt idx="123">
                  <c:v>0.1416</c:v>
                </c:pt>
                <c:pt idx="124">
                  <c:v>9.6500000000000002E-2</c:v>
                </c:pt>
                <c:pt idx="125">
                  <c:v>0.1018</c:v>
                </c:pt>
                <c:pt idx="126">
                  <c:v>5.67E-2</c:v>
                </c:pt>
                <c:pt idx="127">
                  <c:v>5.2600000000000001E-2</c:v>
                </c:pt>
                <c:pt idx="128">
                  <c:v>5.5399999999999998E-2</c:v>
                </c:pt>
                <c:pt idx="129">
                  <c:v>5.2600000000000001E-2</c:v>
                </c:pt>
                <c:pt idx="130">
                  <c:v>0.1018</c:v>
                </c:pt>
                <c:pt idx="131">
                  <c:v>9.0899999999999995E-2</c:v>
                </c:pt>
                <c:pt idx="132">
                  <c:v>6.7699999999999996E-2</c:v>
                </c:pt>
                <c:pt idx="133">
                  <c:v>3.8699999999999998E-2</c:v>
                </c:pt>
                <c:pt idx="134">
                  <c:v>4.1399999999999999E-2</c:v>
                </c:pt>
                <c:pt idx="135">
                  <c:v>3.5000000000000003E-2</c:v>
                </c:pt>
                <c:pt idx="136">
                  <c:v>1.7899999999999999E-2</c:v>
                </c:pt>
                <c:pt idx="137">
                  <c:v>1.7899999999999999E-2</c:v>
                </c:pt>
                <c:pt idx="138">
                  <c:v>1.9400000000000001E-2</c:v>
                </c:pt>
                <c:pt idx="139">
                  <c:v>8.9999999999999993E-3</c:v>
                </c:pt>
                <c:pt idx="140">
                  <c:v>8.6999999999999994E-3</c:v>
                </c:pt>
                <c:pt idx="141">
                  <c:v>9.9000000000000008E-3</c:v>
                </c:pt>
                <c:pt idx="142">
                  <c:v>9.9000000000000008E-3</c:v>
                </c:pt>
                <c:pt idx="143">
                  <c:v>5.4999999999999997E-3</c:v>
                </c:pt>
                <c:pt idx="144">
                  <c:v>6.8999999999999999E-3</c:v>
                </c:pt>
                <c:pt idx="145">
                  <c:v>5.4999999999999997E-3</c:v>
                </c:pt>
                <c:pt idx="146">
                  <c:v>7.0000000000000001E-3</c:v>
                </c:pt>
                <c:pt idx="147">
                  <c:v>1.3100000000000001E-2</c:v>
                </c:pt>
                <c:pt idx="148">
                  <c:v>1.37E-2</c:v>
                </c:pt>
                <c:pt idx="149">
                  <c:v>7.4000000000000003E-3</c:v>
                </c:pt>
                <c:pt idx="150">
                  <c:v>1.2800000000000001E-2</c:v>
                </c:pt>
                <c:pt idx="151">
                  <c:v>7.7999999999999996E-3</c:v>
                </c:pt>
                <c:pt idx="152">
                  <c:v>4.8999999999999998E-3</c:v>
                </c:pt>
                <c:pt idx="153">
                  <c:v>6.1999999999999998E-3</c:v>
                </c:pt>
                <c:pt idx="154">
                  <c:v>1.0200000000000001E-2</c:v>
                </c:pt>
                <c:pt idx="155">
                  <c:v>8.0999999999999996E-3</c:v>
                </c:pt>
                <c:pt idx="156">
                  <c:v>8.0999999999999996E-3</c:v>
                </c:pt>
                <c:pt idx="157">
                  <c:v>1.67E-2</c:v>
                </c:pt>
                <c:pt idx="158">
                  <c:v>9.7000000000000003E-3</c:v>
                </c:pt>
                <c:pt idx="159">
                  <c:v>6.7000000000000002E-3</c:v>
                </c:pt>
                <c:pt idx="160">
                  <c:v>1.24E-2</c:v>
                </c:pt>
                <c:pt idx="161">
                  <c:v>8.9999999999999993E-3</c:v>
                </c:pt>
                <c:pt idx="162">
                  <c:v>1.67E-2</c:v>
                </c:pt>
                <c:pt idx="163">
                  <c:v>2.6800000000000001E-2</c:v>
                </c:pt>
                <c:pt idx="164">
                  <c:v>1.8200000000000001E-2</c:v>
                </c:pt>
                <c:pt idx="165">
                  <c:v>1.41E-2</c:v>
                </c:pt>
                <c:pt idx="166">
                  <c:v>3.27E-2</c:v>
                </c:pt>
                <c:pt idx="167">
                  <c:v>2.6800000000000001E-2</c:v>
                </c:pt>
                <c:pt idx="168">
                  <c:v>2.12E-2</c:v>
                </c:pt>
                <c:pt idx="169">
                  <c:v>8.9999999999999993E-3</c:v>
                </c:pt>
                <c:pt idx="170">
                  <c:v>2.2599999999999999E-2</c:v>
                </c:pt>
                <c:pt idx="171">
                  <c:v>9.4000000000000004E-3</c:v>
                </c:pt>
                <c:pt idx="172">
                  <c:v>1.44E-2</c:v>
                </c:pt>
                <c:pt idx="173">
                  <c:v>2.4500000000000001E-2</c:v>
                </c:pt>
                <c:pt idx="174">
                  <c:v>2.9700000000000001E-2</c:v>
                </c:pt>
                <c:pt idx="175">
                  <c:v>3.5000000000000003E-2</c:v>
                </c:pt>
                <c:pt idx="176">
                  <c:v>7.2300000000000003E-2</c:v>
                </c:pt>
                <c:pt idx="177">
                  <c:v>7.2300000000000003E-2</c:v>
                </c:pt>
                <c:pt idx="178">
                  <c:v>4.6399999999999997E-2</c:v>
                </c:pt>
                <c:pt idx="179">
                  <c:v>6.7699999999999996E-2</c:v>
                </c:pt>
                <c:pt idx="180">
                  <c:v>0.11169999999999999</c:v>
                </c:pt>
                <c:pt idx="181">
                  <c:v>0.1205</c:v>
                </c:pt>
                <c:pt idx="182">
                  <c:v>9.9099999999999994E-2</c:v>
                </c:pt>
                <c:pt idx="183">
                  <c:v>5.5399999999999998E-2</c:v>
                </c:pt>
                <c:pt idx="184">
                  <c:v>4.9000000000000002E-2</c:v>
                </c:pt>
                <c:pt idx="185">
                  <c:v>7.8899999999999998E-2</c:v>
                </c:pt>
                <c:pt idx="186">
                  <c:v>8.8400000000000006E-2</c:v>
                </c:pt>
                <c:pt idx="187">
                  <c:v>5.2600000000000001E-2</c:v>
                </c:pt>
                <c:pt idx="188">
                  <c:v>7.0099999999999996E-2</c:v>
                </c:pt>
                <c:pt idx="189">
                  <c:v>5.0200000000000002E-2</c:v>
                </c:pt>
                <c:pt idx="190">
                  <c:v>5.4199999999999998E-2</c:v>
                </c:pt>
                <c:pt idx="191">
                  <c:v>4.6399999999999997E-2</c:v>
                </c:pt>
                <c:pt idx="192">
                  <c:v>0.1041</c:v>
                </c:pt>
                <c:pt idx="193">
                  <c:v>7.8899999999999998E-2</c:v>
                </c:pt>
                <c:pt idx="194">
                  <c:v>5.4199999999999998E-2</c:v>
                </c:pt>
                <c:pt idx="195">
                  <c:v>4.7800000000000002E-2</c:v>
                </c:pt>
                <c:pt idx="196">
                  <c:v>4.0500000000000001E-2</c:v>
                </c:pt>
                <c:pt idx="197">
                  <c:v>3.3599999999999998E-2</c:v>
                </c:pt>
                <c:pt idx="198">
                  <c:v>4.9000000000000002E-2</c:v>
                </c:pt>
                <c:pt idx="199">
                  <c:v>7.7100000000000002E-2</c:v>
                </c:pt>
                <c:pt idx="200">
                  <c:v>7.2300000000000003E-2</c:v>
                </c:pt>
                <c:pt idx="201">
                  <c:v>7.0099999999999996E-2</c:v>
                </c:pt>
                <c:pt idx="202">
                  <c:v>4.5499999999999999E-2</c:v>
                </c:pt>
                <c:pt idx="203">
                  <c:v>6.4299999999999996E-2</c:v>
                </c:pt>
                <c:pt idx="204">
                  <c:v>0.1416</c:v>
                </c:pt>
                <c:pt idx="205">
                  <c:v>0.18779999999999999</c:v>
                </c:pt>
                <c:pt idx="206">
                  <c:v>0.24829999999999999</c:v>
                </c:pt>
                <c:pt idx="207">
                  <c:v>0.16669999999999999</c:v>
                </c:pt>
                <c:pt idx="208">
                  <c:v>0.1958</c:v>
                </c:pt>
                <c:pt idx="209">
                  <c:v>0.18440000000000001</c:v>
                </c:pt>
                <c:pt idx="210">
                  <c:v>0.23849999999999999</c:v>
                </c:pt>
                <c:pt idx="211">
                  <c:v>0.26569999999999999</c:v>
                </c:pt>
                <c:pt idx="212">
                  <c:v>0.20799999999999999</c:v>
                </c:pt>
                <c:pt idx="213">
                  <c:v>0.1958</c:v>
                </c:pt>
                <c:pt idx="214">
                  <c:v>0.19209999999999999</c:v>
                </c:pt>
                <c:pt idx="215">
                  <c:v>0.25309999999999999</c:v>
                </c:pt>
                <c:pt idx="216">
                  <c:v>0.26019999999999999</c:v>
                </c:pt>
                <c:pt idx="217">
                  <c:v>0.26569999999999999</c:v>
                </c:pt>
                <c:pt idx="218">
                  <c:v>0.29630000000000001</c:v>
                </c:pt>
                <c:pt idx="219">
                  <c:v>0.26019999999999999</c:v>
                </c:pt>
                <c:pt idx="220">
                  <c:v>0.25580000000000003</c:v>
                </c:pt>
                <c:pt idx="221">
                  <c:v>0.28199999999999997</c:v>
                </c:pt>
                <c:pt idx="222">
                  <c:v>0.23330000000000001</c:v>
                </c:pt>
                <c:pt idx="223">
                  <c:v>0.26569999999999999</c:v>
                </c:pt>
                <c:pt idx="224">
                  <c:v>0.27860000000000001</c:v>
                </c:pt>
                <c:pt idx="225">
                  <c:v>0.25580000000000003</c:v>
                </c:pt>
                <c:pt idx="226">
                  <c:v>0.26569999999999999</c:v>
                </c:pt>
                <c:pt idx="227">
                  <c:v>0.26569999999999999</c:v>
                </c:pt>
                <c:pt idx="228">
                  <c:v>0.35349999999999998</c:v>
                </c:pt>
                <c:pt idx="229">
                  <c:v>0.38469999999999999</c:v>
                </c:pt>
                <c:pt idx="230">
                  <c:v>0.39389999999999997</c:v>
                </c:pt>
                <c:pt idx="231">
                  <c:v>0.37619999999999998</c:v>
                </c:pt>
                <c:pt idx="232">
                  <c:v>0.42820000000000003</c:v>
                </c:pt>
                <c:pt idx="233">
                  <c:v>0.43790000000000001</c:v>
                </c:pt>
                <c:pt idx="234">
                  <c:v>0.44579999999999997</c:v>
                </c:pt>
                <c:pt idx="235">
                  <c:v>0.51729999999999998</c:v>
                </c:pt>
                <c:pt idx="236">
                  <c:v>0.55830000000000002</c:v>
                </c:pt>
                <c:pt idx="237">
                  <c:v>0.55830000000000002</c:v>
                </c:pt>
                <c:pt idx="238">
                  <c:v>0.56669999999999998</c:v>
                </c:pt>
                <c:pt idx="239">
                  <c:v>0.57620000000000005</c:v>
                </c:pt>
                <c:pt idx="240">
                  <c:v>0.62929999999999997</c:v>
                </c:pt>
                <c:pt idx="241">
                  <c:v>0.62929999999999997</c:v>
                </c:pt>
                <c:pt idx="242">
                  <c:v>0.62929999999999997</c:v>
                </c:pt>
                <c:pt idx="243">
                  <c:v>0.67559999999999998</c:v>
                </c:pt>
                <c:pt idx="244">
                  <c:v>0.70340000000000003</c:v>
                </c:pt>
                <c:pt idx="245">
                  <c:v>0.70340000000000003</c:v>
                </c:pt>
                <c:pt idx="246">
                  <c:v>0.71109999999999995</c:v>
                </c:pt>
                <c:pt idx="247">
                  <c:v>0.71919999999999995</c:v>
                </c:pt>
                <c:pt idx="248">
                  <c:v>0.7147</c:v>
                </c:pt>
                <c:pt idx="249">
                  <c:v>0.71919999999999995</c:v>
                </c:pt>
                <c:pt idx="250">
                  <c:v>0.66810000000000003</c:v>
                </c:pt>
                <c:pt idx="251">
                  <c:v>0.61739999999999995</c:v>
                </c:pt>
                <c:pt idx="252">
                  <c:v>0.66810000000000003</c:v>
                </c:pt>
                <c:pt idx="253">
                  <c:v>0.67559999999999998</c:v>
                </c:pt>
                <c:pt idx="254">
                  <c:v>0.66039999999999999</c:v>
                </c:pt>
                <c:pt idx="255">
                  <c:v>0.59409999999999996</c:v>
                </c:pt>
                <c:pt idx="256">
                  <c:v>0.59</c:v>
                </c:pt>
                <c:pt idx="257">
                  <c:v>0.48249999999999998</c:v>
                </c:pt>
                <c:pt idx="258">
                  <c:v>0.3992</c:v>
                </c:pt>
                <c:pt idx="259">
                  <c:v>0.42449999999999999</c:v>
                </c:pt>
                <c:pt idx="260">
                  <c:v>0.41489999999999999</c:v>
                </c:pt>
                <c:pt idx="261">
                  <c:v>0.42030000000000001</c:v>
                </c:pt>
                <c:pt idx="262">
                  <c:v>0.41160000000000002</c:v>
                </c:pt>
                <c:pt idx="263">
                  <c:v>0.4037</c:v>
                </c:pt>
                <c:pt idx="264">
                  <c:v>0.31840000000000002</c:v>
                </c:pt>
                <c:pt idx="265">
                  <c:v>0.22090000000000001</c:v>
                </c:pt>
                <c:pt idx="266">
                  <c:v>0.25580000000000003</c:v>
                </c:pt>
                <c:pt idx="267">
                  <c:v>0.16980000000000001</c:v>
                </c:pt>
                <c:pt idx="268">
                  <c:v>0.15659999999999999</c:v>
                </c:pt>
                <c:pt idx="269">
                  <c:v>9.0899999999999995E-2</c:v>
                </c:pt>
                <c:pt idx="270">
                  <c:v>4.7800000000000002E-2</c:v>
                </c:pt>
                <c:pt idx="271">
                  <c:v>3.6299999999999999E-2</c:v>
                </c:pt>
                <c:pt idx="272">
                  <c:v>5.0200000000000002E-2</c:v>
                </c:pt>
                <c:pt idx="273">
                  <c:v>2.4500000000000001E-2</c:v>
                </c:pt>
                <c:pt idx="274">
                  <c:v>1.09E-2</c:v>
                </c:pt>
                <c:pt idx="275">
                  <c:v>1.7899999999999999E-2</c:v>
                </c:pt>
                <c:pt idx="276">
                  <c:v>1.2800000000000001E-2</c:v>
                </c:pt>
                <c:pt idx="277">
                  <c:v>9.7000000000000003E-3</c:v>
                </c:pt>
                <c:pt idx="278">
                  <c:v>9.4000000000000004E-3</c:v>
                </c:pt>
                <c:pt idx="279">
                  <c:v>7.9000000000000008E-3</c:v>
                </c:pt>
                <c:pt idx="280">
                  <c:v>2.8E-3</c:v>
                </c:pt>
                <c:pt idx="281">
                  <c:v>2.8999999999999998E-3</c:v>
                </c:pt>
                <c:pt idx="282">
                  <c:v>2.5999999999999999E-3</c:v>
                </c:pt>
                <c:pt idx="283">
                  <c:v>2.8E-3</c:v>
                </c:pt>
                <c:pt idx="284">
                  <c:v>8.9999999999999998E-4</c:v>
                </c:pt>
                <c:pt idx="285">
                  <c:v>2.0999999999999999E-3</c:v>
                </c:pt>
                <c:pt idx="286">
                  <c:v>1.5E-3</c:v>
                </c:pt>
                <c:pt idx="287">
                  <c:v>1E-3</c:v>
                </c:pt>
                <c:pt idx="288">
                  <c:v>2.5999999999999999E-3</c:v>
                </c:pt>
                <c:pt idx="289">
                  <c:v>2.7000000000000001E-3</c:v>
                </c:pt>
                <c:pt idx="290">
                  <c:v>2.7000000000000001E-3</c:v>
                </c:pt>
                <c:pt idx="291">
                  <c:v>6.1999999999999998E-3</c:v>
                </c:pt>
                <c:pt idx="292">
                  <c:v>1.09E-2</c:v>
                </c:pt>
                <c:pt idx="293">
                  <c:v>9.7000000000000003E-3</c:v>
                </c:pt>
                <c:pt idx="294">
                  <c:v>9.4000000000000004E-3</c:v>
                </c:pt>
                <c:pt idx="295">
                  <c:v>2.12E-2</c:v>
                </c:pt>
                <c:pt idx="296">
                  <c:v>1.24E-2</c:v>
                </c:pt>
                <c:pt idx="297">
                  <c:v>1.6E-2</c:v>
                </c:pt>
                <c:pt idx="298">
                  <c:v>1.0200000000000001E-2</c:v>
                </c:pt>
                <c:pt idx="299">
                  <c:v>2.18E-2</c:v>
                </c:pt>
                <c:pt idx="300">
                  <c:v>4.0500000000000001E-2</c:v>
                </c:pt>
                <c:pt idx="301">
                  <c:v>4.6399999999999997E-2</c:v>
                </c:pt>
                <c:pt idx="302">
                  <c:v>4.5499999999999999E-2</c:v>
                </c:pt>
                <c:pt idx="303">
                  <c:v>2.86E-2</c:v>
                </c:pt>
                <c:pt idx="304">
                  <c:v>2.9700000000000001E-2</c:v>
                </c:pt>
                <c:pt idx="305">
                  <c:v>5.5399999999999998E-2</c:v>
                </c:pt>
                <c:pt idx="306">
                  <c:v>3.27E-2</c:v>
                </c:pt>
                <c:pt idx="307">
                  <c:v>3.8699999999999998E-2</c:v>
                </c:pt>
                <c:pt idx="308">
                  <c:v>2.18E-2</c:v>
                </c:pt>
                <c:pt idx="309">
                  <c:v>2.86E-2</c:v>
                </c:pt>
                <c:pt idx="310">
                  <c:v>2.6800000000000001E-2</c:v>
                </c:pt>
                <c:pt idx="311">
                  <c:v>2.7400000000000001E-2</c:v>
                </c:pt>
                <c:pt idx="312">
                  <c:v>2.4500000000000001E-2</c:v>
                </c:pt>
                <c:pt idx="313">
                  <c:v>1.4999999999999999E-2</c:v>
                </c:pt>
                <c:pt idx="314">
                  <c:v>1.7899999999999999E-2</c:v>
                </c:pt>
                <c:pt idx="315">
                  <c:v>3.8699999999999998E-2</c:v>
                </c:pt>
                <c:pt idx="316">
                  <c:v>4.1399999999999999E-2</c:v>
                </c:pt>
                <c:pt idx="317">
                  <c:v>6.0699999999999997E-2</c:v>
                </c:pt>
                <c:pt idx="318">
                  <c:v>5.1400000000000001E-2</c:v>
                </c:pt>
                <c:pt idx="319">
                  <c:v>5.2600000000000001E-2</c:v>
                </c:pt>
                <c:pt idx="320">
                  <c:v>5.1400000000000001E-2</c:v>
                </c:pt>
                <c:pt idx="321">
                  <c:v>3.1600000000000003E-2</c:v>
                </c:pt>
                <c:pt idx="322">
                  <c:v>5.2600000000000001E-2</c:v>
                </c:pt>
                <c:pt idx="323">
                  <c:v>5.1400000000000001E-2</c:v>
                </c:pt>
                <c:pt idx="324">
                  <c:v>5.5399999999999998E-2</c:v>
                </c:pt>
                <c:pt idx="325">
                  <c:v>5.0200000000000002E-2</c:v>
                </c:pt>
                <c:pt idx="326">
                  <c:v>4.5499999999999999E-2</c:v>
                </c:pt>
                <c:pt idx="327">
                  <c:v>4.7800000000000002E-2</c:v>
                </c:pt>
                <c:pt idx="328">
                  <c:v>4.7800000000000002E-2</c:v>
                </c:pt>
                <c:pt idx="329">
                  <c:v>8.5800000000000001E-2</c:v>
                </c:pt>
                <c:pt idx="330">
                  <c:v>5.4199999999999998E-2</c:v>
                </c:pt>
                <c:pt idx="331">
                  <c:v>2.9700000000000001E-2</c:v>
                </c:pt>
                <c:pt idx="332">
                  <c:v>3.7600000000000001E-2</c:v>
                </c:pt>
                <c:pt idx="333">
                  <c:v>3.95E-2</c:v>
                </c:pt>
                <c:pt idx="334">
                  <c:v>6.0699999999999997E-2</c:v>
                </c:pt>
                <c:pt idx="335">
                  <c:v>6.0699999999999997E-2</c:v>
                </c:pt>
                <c:pt idx="336">
                  <c:v>5.67E-2</c:v>
                </c:pt>
                <c:pt idx="337">
                  <c:v>5.4199999999999998E-2</c:v>
                </c:pt>
                <c:pt idx="338">
                  <c:v>3.95E-2</c:v>
                </c:pt>
                <c:pt idx="339">
                  <c:v>7.0099999999999996E-2</c:v>
                </c:pt>
                <c:pt idx="340">
                  <c:v>8.5800000000000001E-2</c:v>
                </c:pt>
                <c:pt idx="341">
                  <c:v>4.41E-2</c:v>
                </c:pt>
                <c:pt idx="342">
                  <c:v>8.3199999999999996E-2</c:v>
                </c:pt>
                <c:pt idx="343">
                  <c:v>7.8899999999999998E-2</c:v>
                </c:pt>
                <c:pt idx="344">
                  <c:v>7.7100000000000002E-2</c:v>
                </c:pt>
                <c:pt idx="345">
                  <c:v>0.1205</c:v>
                </c:pt>
                <c:pt idx="346">
                  <c:v>7.0099999999999996E-2</c:v>
                </c:pt>
                <c:pt idx="347">
                  <c:v>7.8899999999999998E-2</c:v>
                </c:pt>
                <c:pt idx="348">
                  <c:v>0.124</c:v>
                </c:pt>
                <c:pt idx="349">
                  <c:v>0.18440000000000001</c:v>
                </c:pt>
                <c:pt idx="350">
                  <c:v>0.13220000000000001</c:v>
                </c:pt>
                <c:pt idx="351">
                  <c:v>0.11169999999999999</c:v>
                </c:pt>
                <c:pt idx="352">
                  <c:v>0.18049999999999999</c:v>
                </c:pt>
                <c:pt idx="353">
                  <c:v>0.17660000000000001</c:v>
                </c:pt>
                <c:pt idx="354">
                  <c:v>0.16980000000000001</c:v>
                </c:pt>
                <c:pt idx="355">
                  <c:v>0.11169999999999999</c:v>
                </c:pt>
                <c:pt idx="356">
                  <c:v>0.10879999999999999</c:v>
                </c:pt>
                <c:pt idx="357">
                  <c:v>0.11169999999999999</c:v>
                </c:pt>
                <c:pt idx="358">
                  <c:v>7.4399999999999994E-2</c:v>
                </c:pt>
                <c:pt idx="359">
                  <c:v>8.8400000000000006E-2</c:v>
                </c:pt>
                <c:pt idx="360">
                  <c:v>8.3199999999999996E-2</c:v>
                </c:pt>
                <c:pt idx="361">
                  <c:v>0.115</c:v>
                </c:pt>
                <c:pt idx="362">
                  <c:v>0.12920000000000001</c:v>
                </c:pt>
                <c:pt idx="363">
                  <c:v>0.13220000000000001</c:v>
                </c:pt>
                <c:pt idx="364">
                  <c:v>0.13220000000000001</c:v>
                </c:pt>
                <c:pt idx="365">
                  <c:v>8.3199999999999996E-2</c:v>
                </c:pt>
                <c:pt idx="366">
                  <c:v>4.9000000000000002E-2</c:v>
                </c:pt>
                <c:pt idx="367">
                  <c:v>7.2300000000000003E-2</c:v>
                </c:pt>
                <c:pt idx="368">
                  <c:v>7.4399999999999994E-2</c:v>
                </c:pt>
                <c:pt idx="369">
                  <c:v>4.5499999999999999E-2</c:v>
                </c:pt>
                <c:pt idx="370">
                  <c:v>3.6299999999999999E-2</c:v>
                </c:pt>
                <c:pt idx="371">
                  <c:v>5.2600000000000001E-2</c:v>
                </c:pt>
                <c:pt idx="372">
                  <c:v>5.1400000000000001E-2</c:v>
                </c:pt>
                <c:pt idx="373">
                  <c:v>5.2600000000000001E-2</c:v>
                </c:pt>
                <c:pt idx="374">
                  <c:v>8.3199999999999996E-2</c:v>
                </c:pt>
                <c:pt idx="375">
                  <c:v>5.0200000000000002E-2</c:v>
                </c:pt>
                <c:pt idx="376">
                  <c:v>8.1299999999999997E-2</c:v>
                </c:pt>
                <c:pt idx="377">
                  <c:v>4.41E-2</c:v>
                </c:pt>
                <c:pt idx="378">
                  <c:v>4.41E-2</c:v>
                </c:pt>
                <c:pt idx="379">
                  <c:v>6.2100000000000002E-2</c:v>
                </c:pt>
                <c:pt idx="380">
                  <c:v>4.2500000000000003E-2</c:v>
                </c:pt>
                <c:pt idx="381">
                  <c:v>4.5499999999999999E-2</c:v>
                </c:pt>
                <c:pt idx="382">
                  <c:v>3.7600000000000001E-2</c:v>
                </c:pt>
                <c:pt idx="383">
                  <c:v>3.27E-2</c:v>
                </c:pt>
                <c:pt idx="384">
                  <c:v>2.52E-2</c:v>
                </c:pt>
                <c:pt idx="385">
                  <c:v>2.52E-2</c:v>
                </c:pt>
                <c:pt idx="386">
                  <c:v>2.4500000000000001E-2</c:v>
                </c:pt>
                <c:pt idx="387">
                  <c:v>2.5899999999999999E-2</c:v>
                </c:pt>
                <c:pt idx="388">
                  <c:v>4.2500000000000003E-2</c:v>
                </c:pt>
                <c:pt idx="389">
                  <c:v>3.95E-2</c:v>
                </c:pt>
                <c:pt idx="390">
                  <c:v>6.6000000000000003E-2</c:v>
                </c:pt>
                <c:pt idx="391">
                  <c:v>6.6000000000000003E-2</c:v>
                </c:pt>
                <c:pt idx="392">
                  <c:v>6.6000000000000003E-2</c:v>
                </c:pt>
                <c:pt idx="393">
                  <c:v>9.6500000000000002E-2</c:v>
                </c:pt>
                <c:pt idx="394">
                  <c:v>9.6500000000000002E-2</c:v>
                </c:pt>
                <c:pt idx="395">
                  <c:v>9.6500000000000002E-2</c:v>
                </c:pt>
                <c:pt idx="396">
                  <c:v>0.1532</c:v>
                </c:pt>
                <c:pt idx="397">
                  <c:v>0.16350000000000001</c:v>
                </c:pt>
                <c:pt idx="398">
                  <c:v>0.17660000000000001</c:v>
                </c:pt>
                <c:pt idx="399">
                  <c:v>0.124</c:v>
                </c:pt>
                <c:pt idx="400">
                  <c:v>0.124</c:v>
                </c:pt>
                <c:pt idx="401">
                  <c:v>0.18049999999999999</c:v>
                </c:pt>
                <c:pt idx="402">
                  <c:v>0.1205</c:v>
                </c:pt>
                <c:pt idx="403">
                  <c:v>0.14949999999999999</c:v>
                </c:pt>
                <c:pt idx="404">
                  <c:v>0.16350000000000001</c:v>
                </c:pt>
                <c:pt idx="405">
                  <c:v>0.12920000000000001</c:v>
                </c:pt>
                <c:pt idx="406">
                  <c:v>8.3199999999999996E-2</c:v>
                </c:pt>
                <c:pt idx="407">
                  <c:v>0.13220000000000001</c:v>
                </c:pt>
                <c:pt idx="408">
                  <c:v>0.16350000000000001</c:v>
                </c:pt>
                <c:pt idx="409">
                  <c:v>0.12920000000000001</c:v>
                </c:pt>
                <c:pt idx="410">
                  <c:v>0.16020000000000001</c:v>
                </c:pt>
                <c:pt idx="411">
                  <c:v>0.16350000000000001</c:v>
                </c:pt>
                <c:pt idx="412">
                  <c:v>0.13489999999999999</c:v>
                </c:pt>
                <c:pt idx="413">
                  <c:v>0.1416</c:v>
                </c:pt>
                <c:pt idx="414">
                  <c:v>0.1532</c:v>
                </c:pt>
                <c:pt idx="415">
                  <c:v>0.1041</c:v>
                </c:pt>
                <c:pt idx="416">
                  <c:v>0.106</c:v>
                </c:pt>
                <c:pt idx="417">
                  <c:v>0.106</c:v>
                </c:pt>
                <c:pt idx="418">
                  <c:v>0.10879999999999999</c:v>
                </c:pt>
                <c:pt idx="419">
                  <c:v>0.16350000000000001</c:v>
                </c:pt>
                <c:pt idx="420">
                  <c:v>0.17319999999999999</c:v>
                </c:pt>
                <c:pt idx="421">
                  <c:v>0.13220000000000001</c:v>
                </c:pt>
                <c:pt idx="422">
                  <c:v>0.15659999999999999</c:v>
                </c:pt>
                <c:pt idx="423">
                  <c:v>0.22550000000000001</c:v>
                </c:pt>
                <c:pt idx="424">
                  <c:v>0.18779999999999999</c:v>
                </c:pt>
                <c:pt idx="425">
                  <c:v>0.26569999999999999</c:v>
                </c:pt>
                <c:pt idx="426">
                  <c:v>0.37619999999999998</c:v>
                </c:pt>
                <c:pt idx="427">
                  <c:v>0.35780000000000001</c:v>
                </c:pt>
                <c:pt idx="428">
                  <c:v>0.36680000000000001</c:v>
                </c:pt>
                <c:pt idx="429">
                  <c:v>0.30959999999999999</c:v>
                </c:pt>
                <c:pt idx="430">
                  <c:v>0.31459999999999999</c:v>
                </c:pt>
                <c:pt idx="431">
                  <c:v>0.20799999999999999</c:v>
                </c:pt>
                <c:pt idx="432">
                  <c:v>0.2122</c:v>
                </c:pt>
                <c:pt idx="433">
                  <c:v>0.25580000000000003</c:v>
                </c:pt>
                <c:pt idx="434">
                  <c:v>0.25309999999999999</c:v>
                </c:pt>
                <c:pt idx="435">
                  <c:v>0.17319999999999999</c:v>
                </c:pt>
                <c:pt idx="436">
                  <c:v>0.23849999999999999</c:v>
                </c:pt>
                <c:pt idx="437">
                  <c:v>0.19980000000000001</c:v>
                </c:pt>
                <c:pt idx="438">
                  <c:v>0.19980000000000001</c:v>
                </c:pt>
                <c:pt idx="439">
                  <c:v>0.19980000000000001</c:v>
                </c:pt>
                <c:pt idx="440">
                  <c:v>0.2041</c:v>
                </c:pt>
                <c:pt idx="441">
                  <c:v>0.26019999999999999</c:v>
                </c:pt>
                <c:pt idx="442">
                  <c:v>0.32250000000000001</c:v>
                </c:pt>
                <c:pt idx="443">
                  <c:v>0.23849999999999999</c:v>
                </c:pt>
                <c:pt idx="444">
                  <c:v>0.27</c:v>
                </c:pt>
                <c:pt idx="445">
                  <c:v>0.23849999999999999</c:v>
                </c:pt>
                <c:pt idx="446">
                  <c:v>0.2432</c:v>
                </c:pt>
                <c:pt idx="447">
                  <c:v>0.1416</c:v>
                </c:pt>
                <c:pt idx="448">
                  <c:v>0.16350000000000001</c:v>
                </c:pt>
                <c:pt idx="449">
                  <c:v>0.1018</c:v>
                </c:pt>
                <c:pt idx="450">
                  <c:v>0.16980000000000001</c:v>
                </c:pt>
                <c:pt idx="451">
                  <c:v>0.1416</c:v>
                </c:pt>
                <c:pt idx="452">
                  <c:v>0.13220000000000001</c:v>
                </c:pt>
                <c:pt idx="453">
                  <c:v>8.5800000000000001E-2</c:v>
                </c:pt>
                <c:pt idx="454">
                  <c:v>6.4299999999999996E-2</c:v>
                </c:pt>
                <c:pt idx="455">
                  <c:v>6.7699999999999996E-2</c:v>
                </c:pt>
                <c:pt idx="456">
                  <c:v>0.1178</c:v>
                </c:pt>
                <c:pt idx="457">
                  <c:v>7.0099999999999996E-2</c:v>
                </c:pt>
                <c:pt idx="458">
                  <c:v>9.0899999999999995E-2</c:v>
                </c:pt>
                <c:pt idx="459">
                  <c:v>5.1400000000000001E-2</c:v>
                </c:pt>
                <c:pt idx="460">
                  <c:v>4.9000000000000002E-2</c:v>
                </c:pt>
                <c:pt idx="461">
                  <c:v>4.9000000000000002E-2</c:v>
                </c:pt>
                <c:pt idx="462">
                  <c:v>5.0200000000000002E-2</c:v>
                </c:pt>
                <c:pt idx="463">
                  <c:v>3.27E-2</c:v>
                </c:pt>
                <c:pt idx="464">
                  <c:v>4.5499999999999999E-2</c:v>
                </c:pt>
                <c:pt idx="465">
                  <c:v>3.8699999999999998E-2</c:v>
                </c:pt>
                <c:pt idx="466">
                  <c:v>5.67E-2</c:v>
                </c:pt>
                <c:pt idx="467">
                  <c:v>5.5399999999999998E-2</c:v>
                </c:pt>
                <c:pt idx="468">
                  <c:v>0.106</c:v>
                </c:pt>
                <c:pt idx="469">
                  <c:v>0.14560000000000001</c:v>
                </c:pt>
                <c:pt idx="470">
                  <c:v>0.19209999999999999</c:v>
                </c:pt>
                <c:pt idx="471">
                  <c:v>0.13489999999999999</c:v>
                </c:pt>
                <c:pt idx="472">
                  <c:v>0.11169999999999999</c:v>
                </c:pt>
                <c:pt idx="473">
                  <c:v>0.12659999999999999</c:v>
                </c:pt>
                <c:pt idx="474">
                  <c:v>0.12659999999999999</c:v>
                </c:pt>
                <c:pt idx="475">
                  <c:v>0.2167</c:v>
                </c:pt>
                <c:pt idx="476">
                  <c:v>0.2167</c:v>
                </c:pt>
                <c:pt idx="477">
                  <c:v>0.18779999999999999</c:v>
                </c:pt>
                <c:pt idx="478">
                  <c:v>0.19980000000000001</c:v>
                </c:pt>
                <c:pt idx="479">
                  <c:v>0.19209999999999999</c:v>
                </c:pt>
                <c:pt idx="480">
                  <c:v>0.27860000000000001</c:v>
                </c:pt>
                <c:pt idx="481">
                  <c:v>0.27860000000000001</c:v>
                </c:pt>
                <c:pt idx="482">
                  <c:v>0.27860000000000001</c:v>
                </c:pt>
                <c:pt idx="483">
                  <c:v>0.27479999999999999</c:v>
                </c:pt>
                <c:pt idx="484">
                  <c:v>0.27860000000000001</c:v>
                </c:pt>
                <c:pt idx="485">
                  <c:v>0.30959999999999999</c:v>
                </c:pt>
                <c:pt idx="486">
                  <c:v>0.27860000000000001</c:v>
                </c:pt>
                <c:pt idx="487">
                  <c:v>0.2913</c:v>
                </c:pt>
                <c:pt idx="488">
                  <c:v>0.28649999999999998</c:v>
                </c:pt>
                <c:pt idx="489">
                  <c:v>0.27860000000000001</c:v>
                </c:pt>
                <c:pt idx="490">
                  <c:v>0.22550000000000001</c:v>
                </c:pt>
                <c:pt idx="491">
                  <c:v>0.22919999999999999</c:v>
                </c:pt>
                <c:pt idx="492">
                  <c:v>0.29630000000000001</c:v>
                </c:pt>
                <c:pt idx="493">
                  <c:v>0.36680000000000001</c:v>
                </c:pt>
                <c:pt idx="494">
                  <c:v>0.43790000000000001</c:v>
                </c:pt>
                <c:pt idx="495">
                  <c:v>0.51729999999999998</c:v>
                </c:pt>
                <c:pt idx="496">
                  <c:v>0.4556</c:v>
                </c:pt>
                <c:pt idx="497">
                  <c:v>0.39389999999999997</c:v>
                </c:pt>
                <c:pt idx="498">
                  <c:v>0.42820000000000003</c:v>
                </c:pt>
                <c:pt idx="499">
                  <c:v>0.50080000000000002</c:v>
                </c:pt>
                <c:pt idx="500">
                  <c:v>0.51259999999999994</c:v>
                </c:pt>
                <c:pt idx="501">
                  <c:v>0.46510000000000001</c:v>
                </c:pt>
                <c:pt idx="502">
                  <c:v>0.4556</c:v>
                </c:pt>
                <c:pt idx="503">
                  <c:v>0.45129999999999998</c:v>
                </c:pt>
                <c:pt idx="504">
                  <c:v>0.43790000000000001</c:v>
                </c:pt>
                <c:pt idx="505">
                  <c:v>0.50429999999999997</c:v>
                </c:pt>
                <c:pt idx="506">
                  <c:v>0.49180000000000001</c:v>
                </c:pt>
                <c:pt idx="507">
                  <c:v>0.4556</c:v>
                </c:pt>
                <c:pt idx="508">
                  <c:v>0.3992</c:v>
                </c:pt>
                <c:pt idx="509">
                  <c:v>0.39389999999999997</c:v>
                </c:pt>
                <c:pt idx="510">
                  <c:v>0.3992</c:v>
                </c:pt>
                <c:pt idx="511">
                  <c:v>0.442</c:v>
                </c:pt>
                <c:pt idx="512">
                  <c:v>0.47810000000000002</c:v>
                </c:pt>
                <c:pt idx="513">
                  <c:v>0.48249999999999998</c:v>
                </c:pt>
                <c:pt idx="514">
                  <c:v>0.4879</c:v>
                </c:pt>
                <c:pt idx="515">
                  <c:v>0.47810000000000002</c:v>
                </c:pt>
                <c:pt idx="516">
                  <c:v>0.48249999999999998</c:v>
                </c:pt>
                <c:pt idx="517">
                  <c:v>0.50839999999999996</c:v>
                </c:pt>
                <c:pt idx="518">
                  <c:v>0.53739999999999999</c:v>
                </c:pt>
                <c:pt idx="519">
                  <c:v>0.52529999999999999</c:v>
                </c:pt>
                <c:pt idx="520">
                  <c:v>0.50080000000000002</c:v>
                </c:pt>
                <c:pt idx="521">
                  <c:v>0.49180000000000001</c:v>
                </c:pt>
                <c:pt idx="522">
                  <c:v>0.52529999999999999</c:v>
                </c:pt>
                <c:pt idx="523">
                  <c:v>0.53310000000000002</c:v>
                </c:pt>
                <c:pt idx="524">
                  <c:v>0.54120000000000001</c:v>
                </c:pt>
                <c:pt idx="525">
                  <c:v>0.5514</c:v>
                </c:pt>
                <c:pt idx="526">
                  <c:v>0.54730000000000001</c:v>
                </c:pt>
                <c:pt idx="527">
                  <c:v>0.54730000000000001</c:v>
                </c:pt>
                <c:pt idx="528">
                  <c:v>0.56230000000000002</c:v>
                </c:pt>
                <c:pt idx="529">
                  <c:v>0.56669999999999998</c:v>
                </c:pt>
                <c:pt idx="530">
                  <c:v>0.55830000000000002</c:v>
                </c:pt>
                <c:pt idx="531">
                  <c:v>0.5514</c:v>
                </c:pt>
                <c:pt idx="532">
                  <c:v>0.56669999999999998</c:v>
                </c:pt>
                <c:pt idx="533">
                  <c:v>0.55830000000000002</c:v>
                </c:pt>
                <c:pt idx="534">
                  <c:v>0.5514</c:v>
                </c:pt>
                <c:pt idx="535">
                  <c:v>0.54730000000000001</c:v>
                </c:pt>
                <c:pt idx="536">
                  <c:v>0.56230000000000002</c:v>
                </c:pt>
                <c:pt idx="537">
                  <c:v>0.54730000000000001</c:v>
                </c:pt>
                <c:pt idx="538">
                  <c:v>0.48249999999999998</c:v>
                </c:pt>
                <c:pt idx="539">
                  <c:v>0.442</c:v>
                </c:pt>
                <c:pt idx="540">
                  <c:v>0.43330000000000002</c:v>
                </c:pt>
                <c:pt idx="541">
                  <c:v>0.4556</c:v>
                </c:pt>
                <c:pt idx="542">
                  <c:v>0.42030000000000001</c:v>
                </c:pt>
                <c:pt idx="543">
                  <c:v>0.41489999999999999</c:v>
                </c:pt>
                <c:pt idx="544">
                  <c:v>0.42030000000000001</c:v>
                </c:pt>
                <c:pt idx="545">
                  <c:v>0.41160000000000002</c:v>
                </c:pt>
                <c:pt idx="546">
                  <c:v>0.36299999999999999</c:v>
                </c:pt>
                <c:pt idx="547">
                  <c:v>0.37169999999999997</c:v>
                </c:pt>
                <c:pt idx="548">
                  <c:v>0.37619999999999998</c:v>
                </c:pt>
                <c:pt idx="549">
                  <c:v>0.36680000000000001</c:v>
                </c:pt>
                <c:pt idx="550">
                  <c:v>0.41489999999999999</c:v>
                </c:pt>
                <c:pt idx="551">
                  <c:v>0.4556</c:v>
                </c:pt>
                <c:pt idx="552">
                  <c:v>0.38469999999999999</c:v>
                </c:pt>
                <c:pt idx="553">
                  <c:v>0.38469999999999999</c:v>
                </c:pt>
                <c:pt idx="554">
                  <c:v>0.38469999999999999</c:v>
                </c:pt>
                <c:pt idx="555">
                  <c:v>0.3992</c:v>
                </c:pt>
                <c:pt idx="556">
                  <c:v>0.38850000000000001</c:v>
                </c:pt>
                <c:pt idx="557">
                  <c:v>0.37619999999999998</c:v>
                </c:pt>
                <c:pt idx="558">
                  <c:v>0.38059999999999999</c:v>
                </c:pt>
                <c:pt idx="559">
                  <c:v>0.442</c:v>
                </c:pt>
                <c:pt idx="560">
                  <c:v>0.50429999999999997</c:v>
                </c:pt>
                <c:pt idx="561">
                  <c:v>0.51259999999999994</c:v>
                </c:pt>
                <c:pt idx="562">
                  <c:v>0.46</c:v>
                </c:pt>
                <c:pt idx="563">
                  <c:v>0.49669999999999997</c:v>
                </c:pt>
                <c:pt idx="564">
                  <c:v>0.49669999999999997</c:v>
                </c:pt>
                <c:pt idx="565">
                  <c:v>0.49180000000000001</c:v>
                </c:pt>
                <c:pt idx="566">
                  <c:v>0.43790000000000001</c:v>
                </c:pt>
                <c:pt idx="567">
                  <c:v>0.49669999999999997</c:v>
                </c:pt>
                <c:pt idx="568">
                  <c:v>0.50080000000000002</c:v>
                </c:pt>
                <c:pt idx="569">
                  <c:v>0.45129999999999998</c:v>
                </c:pt>
                <c:pt idx="570">
                  <c:v>0.49669999999999997</c:v>
                </c:pt>
                <c:pt idx="571">
                  <c:v>0.43330000000000002</c:v>
                </c:pt>
                <c:pt idx="572">
                  <c:v>0.3992</c:v>
                </c:pt>
                <c:pt idx="573">
                  <c:v>0.47810000000000002</c:v>
                </c:pt>
                <c:pt idx="574">
                  <c:v>0.50839999999999996</c:v>
                </c:pt>
                <c:pt idx="575">
                  <c:v>0.50429999999999997</c:v>
                </c:pt>
                <c:pt idx="576">
                  <c:v>0.49669999999999997</c:v>
                </c:pt>
                <c:pt idx="577">
                  <c:v>0.50080000000000002</c:v>
                </c:pt>
                <c:pt idx="578">
                  <c:v>0.49669999999999997</c:v>
                </c:pt>
                <c:pt idx="579">
                  <c:v>0.44579999999999997</c:v>
                </c:pt>
                <c:pt idx="580">
                  <c:v>0.46</c:v>
                </c:pt>
                <c:pt idx="581">
                  <c:v>0.41489999999999999</c:v>
                </c:pt>
                <c:pt idx="582">
                  <c:v>0.41489999999999999</c:v>
                </c:pt>
                <c:pt idx="583">
                  <c:v>0.51259999999999994</c:v>
                </c:pt>
                <c:pt idx="584">
                  <c:v>0.55830000000000002</c:v>
                </c:pt>
                <c:pt idx="585">
                  <c:v>0.6079</c:v>
                </c:pt>
                <c:pt idx="586">
                  <c:v>0.65159999999999996</c:v>
                </c:pt>
                <c:pt idx="587">
                  <c:v>0.73880000000000001</c:v>
                </c:pt>
                <c:pt idx="588">
                  <c:v>0.76880000000000004</c:v>
                </c:pt>
                <c:pt idx="589">
                  <c:v>0.80359999999999998</c:v>
                </c:pt>
                <c:pt idx="590">
                  <c:v>0.87460000000000004</c:v>
                </c:pt>
                <c:pt idx="591">
                  <c:v>0.9103</c:v>
                </c:pt>
                <c:pt idx="592">
                  <c:v>0.9604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D0F-244A-8A21-C7428CB7F459}"/>
            </c:ext>
          </c:extLst>
        </c:ser>
        <c:ser>
          <c:idx val="0"/>
          <c:order val="2"/>
          <c:tx>
            <c:v>Threshold</c:v>
          </c:tx>
          <c:spPr>
            <a:ln w="952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Sheet1!$J$2:$J$3</c:f>
              <c:numCache>
                <c:formatCode>General</c:formatCode>
                <c:ptCount val="2"/>
                <c:pt idx="0">
                  <c:v>1</c:v>
                </c:pt>
                <c:pt idx="1">
                  <c:v>600</c:v>
                </c:pt>
              </c:numCache>
            </c:numRef>
          </c:xVal>
          <c:yVal>
            <c:numRef>
              <c:f>Sheet1!$K$2:$K$3</c:f>
              <c:numCache>
                <c:formatCode>General</c:formatCode>
                <c:ptCount val="2"/>
                <c:pt idx="0">
                  <c:v>0.5</c:v>
                </c:pt>
                <c:pt idx="1">
                  <c:v>0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D0F-244A-8A21-C7428CB7F4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50783119"/>
        <c:axId val="997122959"/>
      </c:scatterChart>
      <c:valAx>
        <c:axId val="1050783119"/>
        <c:scaling>
          <c:orientation val="minMax"/>
          <c:max val="6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Residue Number  </a:t>
                </a:r>
              </a:p>
            </c:rich>
          </c:tx>
          <c:layout>
            <c:manualLayout>
              <c:xMode val="edge"/>
              <c:yMode val="edge"/>
              <c:x val="0.3205709595959596"/>
              <c:y val="0.873224242424242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7122959"/>
        <c:crosses val="autoZero"/>
        <c:crossBetween val="midCat"/>
        <c:majorUnit val="100"/>
        <c:minorUnit val="100"/>
      </c:valAx>
      <c:valAx>
        <c:axId val="997122959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Disorder probability</a:t>
                </a:r>
              </a:p>
            </c:rich>
          </c:tx>
          <c:layout>
            <c:manualLayout>
              <c:xMode val="edge"/>
              <c:yMode val="edge"/>
              <c:x val="2.2449494949494948E-2"/>
              <c:y val="0.185086868686868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078311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711590909090907"/>
          <c:y val="0.18864090909090905"/>
          <c:w val="0.22119217171717168"/>
          <c:h val="0.252835648148148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+mn-lt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7192</cdr:x>
      <cdr:y>0.20809</cdr:y>
    </cdr:from>
    <cdr:to>
      <cdr:x>0.69552</cdr:x>
      <cdr:y>0.22552</cdr:y>
    </cdr:to>
    <cdr:sp macro="" textlink="">
      <cdr:nvSpPr>
        <cdr:cNvPr id="2" name="Rectangle 1">
          <a:extLst xmlns:a="http://schemas.openxmlformats.org/drawingml/2006/main">
            <a:ext uri="{FF2B5EF4-FFF2-40B4-BE49-F238E27FC236}">
              <a16:creationId xmlns:a16="http://schemas.microsoft.com/office/drawing/2014/main" id="{8E95045C-E09E-BDF3-F4A5-2A22FD0DD92F}"/>
            </a:ext>
          </a:extLst>
        </cdr:cNvPr>
        <cdr:cNvSpPr/>
      </cdr:nvSpPr>
      <cdr:spPr>
        <a:xfrm xmlns:a="http://schemas.openxmlformats.org/drawingml/2006/main">
          <a:off x="2621441" y="546001"/>
          <a:ext cx="92075" cy="45719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6E5580-2391-2548-90E6-AC7E7DD431AD}" type="datetimeFigureOut">
              <a:rPr lang="en-US" smtClean="0"/>
              <a:t>3/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039D23-EF11-6A4A-8C00-7220139672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8834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542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529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56218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31822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834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441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073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653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254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287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62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666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322DE-FDFC-3F4F-8F74-8723A5E8115B}" type="datetimeFigureOut">
              <a:rPr lang="en-US" smtClean="0"/>
              <a:t>3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700C76-83BA-A140-93EF-C3437A03E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448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0011FE2-6D39-7A02-01CB-5A31BD875D7B}"/>
              </a:ext>
            </a:extLst>
          </p:cNvPr>
          <p:cNvSpPr txBox="1"/>
          <p:nvPr/>
        </p:nvSpPr>
        <p:spPr>
          <a:xfrm>
            <a:off x="259711" y="102802"/>
            <a:ext cx="9466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ure S1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2C42F349-C7A7-4DE4-3D80-C95CB1F830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977607"/>
              </p:ext>
            </p:extLst>
          </p:nvPr>
        </p:nvGraphicFramePr>
        <p:xfrm>
          <a:off x="528159" y="803374"/>
          <a:ext cx="3901440" cy="2623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FFB056F-4C99-4661-F305-5383CF191657}"/>
              </a:ext>
            </a:extLst>
          </p:cNvPr>
          <p:cNvSpPr txBox="1"/>
          <p:nvPr/>
        </p:nvSpPr>
        <p:spPr>
          <a:xfrm>
            <a:off x="2261693" y="3102357"/>
            <a:ext cx="11673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Relative abundance (%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205FB25-1879-7F44-345F-B2E6ABC0D63C}"/>
              </a:ext>
            </a:extLst>
          </p:cNvPr>
          <p:cNvSpPr/>
          <p:nvPr/>
        </p:nvSpPr>
        <p:spPr>
          <a:xfrm>
            <a:off x="3298797" y="1221362"/>
            <a:ext cx="267536" cy="3566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B2B6810A-0B5C-3813-28AA-5DC2D8A4A9EA}"/>
              </a:ext>
            </a:extLst>
          </p:cNvPr>
          <p:cNvCxnSpPr/>
          <p:nvPr/>
        </p:nvCxnSpPr>
        <p:spPr>
          <a:xfrm>
            <a:off x="3292447" y="1295400"/>
            <a:ext cx="9842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D1EDC8CD-A3B6-9D6D-B208-879FF3D6D711}"/>
              </a:ext>
            </a:extLst>
          </p:cNvPr>
          <p:cNvCxnSpPr/>
          <p:nvPr/>
        </p:nvCxnSpPr>
        <p:spPr>
          <a:xfrm>
            <a:off x="3281306" y="1485900"/>
            <a:ext cx="9842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4255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CA1AFD5F-17FD-A94E-B816-7DDAA4A64E17}"/>
              </a:ext>
            </a:extLst>
          </p:cNvPr>
          <p:cNvCxnSpPr/>
          <p:nvPr/>
        </p:nvCxnSpPr>
        <p:spPr>
          <a:xfrm>
            <a:off x="1656210" y="1755899"/>
            <a:ext cx="12225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150633AF-6BAE-7D4B-93D6-24878E5F7A12}"/>
              </a:ext>
            </a:extLst>
          </p:cNvPr>
          <p:cNvCxnSpPr/>
          <p:nvPr/>
        </p:nvCxnSpPr>
        <p:spPr>
          <a:xfrm>
            <a:off x="1657460" y="2099458"/>
            <a:ext cx="12225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AE475D6B-5680-2144-AACA-4F9B30A5E3FE}"/>
              </a:ext>
            </a:extLst>
          </p:cNvPr>
          <p:cNvCxnSpPr/>
          <p:nvPr/>
        </p:nvCxnSpPr>
        <p:spPr>
          <a:xfrm>
            <a:off x="1659887" y="2431585"/>
            <a:ext cx="11857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59C985FA-B9B1-BB41-86B1-7181E457753B}"/>
              </a:ext>
            </a:extLst>
          </p:cNvPr>
          <p:cNvSpPr txBox="1"/>
          <p:nvPr/>
        </p:nvSpPr>
        <p:spPr>
          <a:xfrm>
            <a:off x="259711" y="102802"/>
            <a:ext cx="9466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ure S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BA4961E-30A9-9B42-B53A-67736D56CD9B}"/>
              </a:ext>
            </a:extLst>
          </p:cNvPr>
          <p:cNvSpPr txBox="1"/>
          <p:nvPr/>
        </p:nvSpPr>
        <p:spPr>
          <a:xfrm rot="1800000">
            <a:off x="2080182" y="1436380"/>
            <a:ext cx="104644" cy="26029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i="1" dirty="0"/>
              <a:t>nch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C021D2-0D93-4044-98D8-BFD796296AAC}"/>
              </a:ext>
            </a:extLst>
          </p:cNvPr>
          <p:cNvSpPr txBox="1"/>
          <p:nvPr/>
        </p:nvSpPr>
        <p:spPr>
          <a:xfrm rot="1800000">
            <a:off x="2350813" y="1168850"/>
            <a:ext cx="104644" cy="547030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i="1" dirty="0"/>
              <a:t>rpt2 nch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ABEC937-C3E3-C046-8CAC-E4ADA7B4DEF2}"/>
              </a:ext>
            </a:extLst>
          </p:cNvPr>
          <p:cNvSpPr txBox="1"/>
          <p:nvPr/>
        </p:nvSpPr>
        <p:spPr>
          <a:xfrm rot="1800000">
            <a:off x="1850665" y="1528814"/>
            <a:ext cx="104644" cy="161221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7257B62-560B-3D48-94EF-73367F943B8A}"/>
              </a:ext>
            </a:extLst>
          </p:cNvPr>
          <p:cNvSpPr txBox="1"/>
          <p:nvPr/>
        </p:nvSpPr>
        <p:spPr>
          <a:xfrm rot="1800000">
            <a:off x="2524125" y="1459379"/>
            <a:ext cx="104644" cy="23564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18-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18C36F7-EB3B-B14C-BB1A-7F8A195C13B0}"/>
              </a:ext>
            </a:extLst>
          </p:cNvPr>
          <p:cNvSpPr txBox="1"/>
          <p:nvPr/>
        </p:nvSpPr>
        <p:spPr>
          <a:xfrm rot="1800000">
            <a:off x="2777162" y="1459379"/>
            <a:ext cx="104644" cy="23564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21-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2A20318-024A-7949-8B75-B5CAD203EFBE}"/>
              </a:ext>
            </a:extLst>
          </p:cNvPr>
          <p:cNvSpPr txBox="1"/>
          <p:nvPr/>
        </p:nvSpPr>
        <p:spPr>
          <a:xfrm rot="1800000">
            <a:off x="3033458" y="1459379"/>
            <a:ext cx="104644" cy="23564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27-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8F052BE-7478-4847-9684-974C25973DDE}"/>
              </a:ext>
            </a:extLst>
          </p:cNvPr>
          <p:cNvSpPr txBox="1"/>
          <p:nvPr/>
        </p:nvSpPr>
        <p:spPr>
          <a:xfrm rot="1800000">
            <a:off x="3301899" y="1459379"/>
            <a:ext cx="104644" cy="23564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28-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3D163D4-347C-D943-806A-1D0A1C706DB3}"/>
              </a:ext>
            </a:extLst>
          </p:cNvPr>
          <p:cNvSpPr txBox="1"/>
          <p:nvPr/>
        </p:nvSpPr>
        <p:spPr>
          <a:xfrm rot="1800000">
            <a:off x="3540467" y="1520700"/>
            <a:ext cx="104644" cy="169918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2-4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D42A2EE-BFF5-6047-A1A0-59C0E8691A9E}"/>
              </a:ext>
            </a:extLst>
          </p:cNvPr>
          <p:cNvSpPr txBox="1"/>
          <p:nvPr/>
        </p:nvSpPr>
        <p:spPr>
          <a:xfrm rot="1800000">
            <a:off x="3770134" y="1520700"/>
            <a:ext cx="104644" cy="169918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4-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8E0B12E-49A4-3341-A2F6-C4C3D0A037B9}"/>
              </a:ext>
            </a:extLst>
          </p:cNvPr>
          <p:cNvSpPr txBox="1"/>
          <p:nvPr/>
        </p:nvSpPr>
        <p:spPr>
          <a:xfrm rot="1800000">
            <a:off x="3993098" y="1520700"/>
            <a:ext cx="104644" cy="169918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5-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63FD369-E99F-EE4B-A0CF-AD0B221B6E70}"/>
              </a:ext>
            </a:extLst>
          </p:cNvPr>
          <p:cNvSpPr txBox="1"/>
          <p:nvPr/>
        </p:nvSpPr>
        <p:spPr>
          <a:xfrm rot="1800000">
            <a:off x="4220546" y="1459379"/>
            <a:ext cx="104644" cy="23564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6-1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BBD5533-9810-9B46-B64C-0ECDC456E5C1}"/>
              </a:ext>
            </a:extLst>
          </p:cNvPr>
          <p:cNvSpPr txBox="1"/>
          <p:nvPr/>
        </p:nvSpPr>
        <p:spPr>
          <a:xfrm rot="1800000">
            <a:off x="4455825" y="1459379"/>
            <a:ext cx="104644" cy="23564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12-6</a:t>
            </a:r>
          </a:p>
        </p:txBody>
      </p:sp>
      <p:pic>
        <p:nvPicPr>
          <p:cNvPr id="45" name="Picture 44" descr="A close-up of a graph&#10;&#10;Description automatically generated with low confidence">
            <a:extLst>
              <a:ext uri="{FF2B5EF4-FFF2-40B4-BE49-F238E27FC236}">
                <a16:creationId xmlns:a16="http://schemas.microsoft.com/office/drawing/2014/main" id="{23CA8E95-3FC1-8645-A10C-390F9F353A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668" t="46651" r="4082" b="39585"/>
          <a:stretch/>
        </p:blipFill>
        <p:spPr>
          <a:xfrm>
            <a:off x="1709299" y="2527635"/>
            <a:ext cx="3110505" cy="2832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2796A06E-D926-CE41-B4C9-44EB552501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767" t="40200" r="8432" b="26495"/>
          <a:stretch/>
        </p:blipFill>
        <p:spPr>
          <a:xfrm>
            <a:off x="1709302" y="1743798"/>
            <a:ext cx="3110505" cy="7070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003E5788-DBAD-D148-B581-3F29256E9434}"/>
              </a:ext>
            </a:extLst>
          </p:cNvPr>
          <p:cNvSpPr txBox="1"/>
          <p:nvPr/>
        </p:nvSpPr>
        <p:spPr>
          <a:xfrm>
            <a:off x="4891010" y="2608364"/>
            <a:ext cx="429858" cy="104644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rtlCol="0" anchor="ctr" anchorCtr="0">
            <a:spAutoFit/>
          </a:bodyPr>
          <a:lstStyle/>
          <a:p>
            <a:r>
              <a:rPr lang="en-US" sz="680" dirty="0"/>
              <a:t>Ponceau 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C6F27C9-1F4F-C84C-A1FD-5A4FDB4BE58B}"/>
              </a:ext>
            </a:extLst>
          </p:cNvPr>
          <p:cNvSpPr txBox="1"/>
          <p:nvPr/>
        </p:nvSpPr>
        <p:spPr>
          <a:xfrm>
            <a:off x="4891010" y="2045336"/>
            <a:ext cx="211068" cy="104644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rtlCol="0" anchor="ctr" anchorCtr="0">
            <a:spAutoFit/>
          </a:bodyPr>
          <a:lstStyle/>
          <a:p>
            <a:r>
              <a:rPr lang="en-US" sz="680" dirty="0"/>
              <a:t>RPT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79F554B-3C3C-3441-BFE6-75E00058B38F}"/>
              </a:ext>
            </a:extLst>
          </p:cNvPr>
          <p:cNvSpPr txBox="1"/>
          <p:nvPr/>
        </p:nvSpPr>
        <p:spPr>
          <a:xfrm>
            <a:off x="1473695" y="1704341"/>
            <a:ext cx="158301" cy="104644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ctr" anchorCtr="0">
            <a:spAutoFit/>
          </a:bodyPr>
          <a:lstStyle/>
          <a:p>
            <a:pPr algn="just"/>
            <a:r>
              <a:rPr lang="en-US" sz="680" dirty="0"/>
              <a:t>10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62F1B19-6F0C-0D48-BC25-33C5E3128C25}"/>
              </a:ext>
            </a:extLst>
          </p:cNvPr>
          <p:cNvSpPr txBox="1"/>
          <p:nvPr/>
        </p:nvSpPr>
        <p:spPr>
          <a:xfrm>
            <a:off x="1526462" y="2055458"/>
            <a:ext cx="105534" cy="104644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ctr" anchorCtr="0">
            <a:spAutoFit/>
          </a:bodyPr>
          <a:lstStyle/>
          <a:p>
            <a:pPr algn="just"/>
            <a:r>
              <a:rPr lang="en-US" sz="680" dirty="0"/>
              <a:t>7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B03FD1A-AD3C-AE42-916C-B9435C974320}"/>
              </a:ext>
            </a:extLst>
          </p:cNvPr>
          <p:cNvSpPr txBox="1"/>
          <p:nvPr/>
        </p:nvSpPr>
        <p:spPr>
          <a:xfrm>
            <a:off x="1473695" y="1600753"/>
            <a:ext cx="158301" cy="104644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ctr" anchorCtr="0">
            <a:spAutoFit/>
          </a:bodyPr>
          <a:lstStyle/>
          <a:p>
            <a:pPr algn="just"/>
            <a:r>
              <a:rPr lang="en-US" sz="680" dirty="0" err="1"/>
              <a:t>kDa</a:t>
            </a:r>
            <a:endParaRPr lang="en-US" sz="68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29AD690-5E92-5147-9715-AE89684B8752}"/>
              </a:ext>
            </a:extLst>
          </p:cNvPr>
          <p:cNvSpPr txBox="1"/>
          <p:nvPr/>
        </p:nvSpPr>
        <p:spPr>
          <a:xfrm>
            <a:off x="1511064" y="2386043"/>
            <a:ext cx="105300" cy="104644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ctr" anchorCtr="0">
            <a:spAutoFit/>
          </a:bodyPr>
          <a:lstStyle/>
          <a:p>
            <a:pPr algn="just"/>
            <a:r>
              <a:rPr lang="en-US" sz="680" dirty="0"/>
              <a:t>5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22465D6-3F54-BF4D-B1B5-95D590EEBACB}"/>
              </a:ext>
            </a:extLst>
          </p:cNvPr>
          <p:cNvSpPr txBox="1"/>
          <p:nvPr/>
        </p:nvSpPr>
        <p:spPr>
          <a:xfrm rot="1800000">
            <a:off x="4680183" y="1465881"/>
            <a:ext cx="104644" cy="235642"/>
          </a:xfrm>
          <a:prstGeom prst="rect">
            <a:avLst/>
          </a:prstGeom>
          <a:noFill/>
          <a:ln>
            <a:noFill/>
          </a:ln>
        </p:spPr>
        <p:txBody>
          <a:bodyPr vert="vert270" wrap="square" lIns="0" tIns="0" rIns="0" bIns="0" rtlCol="0" anchor="ctr" anchorCtr="0">
            <a:spAutoFit/>
          </a:bodyPr>
          <a:lstStyle/>
          <a:p>
            <a:r>
              <a:rPr lang="en-US" sz="680" dirty="0"/>
              <a:t>13-1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B22B438-023C-2045-BED7-C2F8DBE23212}"/>
              </a:ext>
            </a:extLst>
          </p:cNvPr>
          <p:cNvCxnSpPr>
            <a:cxnSpLocks/>
          </p:cNvCxnSpPr>
          <p:nvPr/>
        </p:nvCxnSpPr>
        <p:spPr>
          <a:xfrm>
            <a:off x="2448119" y="1497757"/>
            <a:ext cx="97752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87A0E243-EA99-EB4B-BE3B-689E7EBB19BF}"/>
              </a:ext>
            </a:extLst>
          </p:cNvPr>
          <p:cNvCxnSpPr>
            <a:cxnSpLocks/>
          </p:cNvCxnSpPr>
          <p:nvPr/>
        </p:nvCxnSpPr>
        <p:spPr>
          <a:xfrm>
            <a:off x="3495323" y="1497757"/>
            <a:ext cx="126552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37948A1D-7354-A14D-B577-9B6070728F4E}"/>
              </a:ext>
            </a:extLst>
          </p:cNvPr>
          <p:cNvSpPr txBox="1"/>
          <p:nvPr/>
        </p:nvSpPr>
        <p:spPr>
          <a:xfrm>
            <a:off x="2829984" y="1352785"/>
            <a:ext cx="322204" cy="107722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sz="700" dirty="0"/>
              <a:t>RPT2</a:t>
            </a:r>
            <a:endParaRPr lang="en-US" sz="700" baseline="30000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5AD80F5-937C-744A-835D-B0D07336D0F5}"/>
              </a:ext>
            </a:extLst>
          </p:cNvPr>
          <p:cNvSpPr txBox="1"/>
          <p:nvPr/>
        </p:nvSpPr>
        <p:spPr>
          <a:xfrm>
            <a:off x="3867896" y="1352785"/>
            <a:ext cx="423193" cy="107722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sz="700" dirty="0"/>
              <a:t>S591A</a:t>
            </a:r>
          </a:p>
        </p:txBody>
      </p:sp>
    </p:spTree>
    <p:extLst>
      <p:ext uri="{BB962C8B-B14F-4D97-AF65-F5344CB8AC3E}">
        <p14:creationId xmlns:p14="http://schemas.microsoft.com/office/powerpoint/2010/main" val="4096866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7A56F7-2283-7349-864C-32BBE0456E54}"/>
              </a:ext>
            </a:extLst>
          </p:cNvPr>
          <p:cNvSpPr txBox="1"/>
          <p:nvPr/>
        </p:nvSpPr>
        <p:spPr>
          <a:xfrm>
            <a:off x="259711" y="102802"/>
            <a:ext cx="9466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ure S3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6883FED-43F7-BE98-3385-47EB89DE7C4C}"/>
              </a:ext>
            </a:extLst>
          </p:cNvPr>
          <p:cNvGrpSpPr/>
          <p:nvPr/>
        </p:nvGrpSpPr>
        <p:grpSpPr>
          <a:xfrm>
            <a:off x="553174" y="735637"/>
            <a:ext cx="3012986" cy="2075984"/>
            <a:chOff x="1543096" y="2622494"/>
            <a:chExt cx="3203075" cy="2075984"/>
          </a:xfrm>
        </p:grpSpPr>
        <p:graphicFrame>
          <p:nvGraphicFramePr>
            <p:cNvPr id="13" name="Chart 12">
              <a:extLst>
                <a:ext uri="{FF2B5EF4-FFF2-40B4-BE49-F238E27FC236}">
                  <a16:creationId xmlns:a16="http://schemas.microsoft.com/office/drawing/2014/main" id="{E8532162-CBD3-EA4A-9287-A5DFED83DB5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1158824"/>
                </p:ext>
              </p:extLst>
            </p:nvPr>
          </p:nvGraphicFramePr>
          <p:xfrm>
            <a:off x="1543096" y="2622494"/>
            <a:ext cx="3203075" cy="20283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TextBox 133">
              <a:extLst>
                <a:ext uri="{FF2B5EF4-FFF2-40B4-BE49-F238E27FC236}">
                  <a16:creationId xmlns:a16="http://schemas.microsoft.com/office/drawing/2014/main" id="{9846FDAA-490B-4004-60B4-2B11C418AF25}"/>
                </a:ext>
              </a:extLst>
            </p:cNvPr>
            <p:cNvSpPr txBox="1"/>
            <p:nvPr/>
          </p:nvSpPr>
          <p:spPr>
            <a:xfrm>
              <a:off x="2729244" y="4575367"/>
              <a:ext cx="836205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dirty="0"/>
                <a:t>Time (hours) </a:t>
              </a:r>
            </a:p>
          </p:txBody>
        </p:sp>
        <p:sp>
          <p:nvSpPr>
            <p:cNvPr id="15" name="TextBox 133">
              <a:extLst>
                <a:ext uri="{FF2B5EF4-FFF2-40B4-BE49-F238E27FC236}">
                  <a16:creationId xmlns:a16="http://schemas.microsoft.com/office/drawing/2014/main" id="{194F3AE7-F9D3-0B55-5C17-95DA44B54500}"/>
                </a:ext>
              </a:extLst>
            </p:cNvPr>
            <p:cNvSpPr txBox="1"/>
            <p:nvPr/>
          </p:nvSpPr>
          <p:spPr>
            <a:xfrm rot="16200000">
              <a:off x="962168" y="3454885"/>
              <a:ext cx="1284967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i="1" dirty="0"/>
                <a:t>RTP2/ISU1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BC4D800-650B-0DEC-4DBB-D7890C569E50}"/>
                </a:ext>
              </a:extLst>
            </p:cNvPr>
            <p:cNvSpPr/>
            <p:nvPr/>
          </p:nvSpPr>
          <p:spPr>
            <a:xfrm>
              <a:off x="2494069" y="2854681"/>
              <a:ext cx="563200" cy="3307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TextBox 152">
              <a:extLst>
                <a:ext uri="{FF2B5EF4-FFF2-40B4-BE49-F238E27FC236}">
                  <a16:creationId xmlns:a16="http://schemas.microsoft.com/office/drawing/2014/main" id="{C171F32D-E567-D38B-27AB-CCDEB77A0853}"/>
                </a:ext>
              </a:extLst>
            </p:cNvPr>
            <p:cNvSpPr txBox="1"/>
            <p:nvPr/>
          </p:nvSpPr>
          <p:spPr>
            <a:xfrm>
              <a:off x="2541316" y="2859532"/>
              <a:ext cx="156356" cy="107722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dirty="0"/>
                <a:t>WT</a:t>
              </a:r>
            </a:p>
          </p:txBody>
        </p:sp>
        <p:sp>
          <p:nvSpPr>
            <p:cNvPr id="18" name="TextBox 152">
              <a:extLst>
                <a:ext uri="{FF2B5EF4-FFF2-40B4-BE49-F238E27FC236}">
                  <a16:creationId xmlns:a16="http://schemas.microsoft.com/office/drawing/2014/main" id="{70584713-5F38-0F2D-DD59-AB8C34FE98E5}"/>
                </a:ext>
              </a:extLst>
            </p:cNvPr>
            <p:cNvSpPr txBox="1"/>
            <p:nvPr/>
          </p:nvSpPr>
          <p:spPr>
            <a:xfrm>
              <a:off x="2541316" y="3004473"/>
              <a:ext cx="621025" cy="107722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i="1" dirty="0"/>
                <a:t>phot1 phot2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476B57D0-4327-B202-1F4D-40AE1F141F10}"/>
                </a:ext>
              </a:extLst>
            </p:cNvPr>
            <p:cNvSpPr/>
            <p:nvPr/>
          </p:nvSpPr>
          <p:spPr>
            <a:xfrm>
              <a:off x="4254144" y="4154614"/>
              <a:ext cx="419455" cy="3990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2017357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E147E10-241C-F692-A576-A9422B1EB7A5}"/>
              </a:ext>
            </a:extLst>
          </p:cNvPr>
          <p:cNvSpPr txBox="1"/>
          <p:nvPr/>
        </p:nvSpPr>
        <p:spPr>
          <a:xfrm>
            <a:off x="259711" y="102802"/>
            <a:ext cx="9466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ure S4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99A277E-71FF-7DF7-BD73-75D039BA4951}"/>
              </a:ext>
            </a:extLst>
          </p:cNvPr>
          <p:cNvGrpSpPr/>
          <p:nvPr/>
        </p:nvGrpSpPr>
        <p:grpSpPr>
          <a:xfrm>
            <a:off x="620713" y="914121"/>
            <a:ext cx="3960000" cy="2039702"/>
            <a:chOff x="620713" y="1599927"/>
            <a:chExt cx="3960000" cy="2039702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7EC70BAE-32AE-3345-6088-93E558E2548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02310521"/>
                </p:ext>
              </p:extLst>
            </p:nvPr>
          </p:nvGraphicFramePr>
          <p:xfrm>
            <a:off x="620713" y="1659629"/>
            <a:ext cx="3960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D7DF544-641C-A958-5594-11BCE9DAD30F}"/>
                </a:ext>
              </a:extLst>
            </p:cNvPr>
            <p:cNvGrpSpPr/>
            <p:nvPr/>
          </p:nvGrpSpPr>
          <p:grpSpPr>
            <a:xfrm>
              <a:off x="1143000" y="1599927"/>
              <a:ext cx="2236788" cy="200055"/>
              <a:chOff x="1163638" y="4075535"/>
              <a:chExt cx="2208212" cy="200055"/>
            </a:xfrm>
          </p:grpSpPr>
          <p:sp>
            <p:nvSpPr>
              <p:cNvPr id="6" name="Rounded Rectangle 5">
                <a:extLst>
                  <a:ext uri="{FF2B5EF4-FFF2-40B4-BE49-F238E27FC236}">
                    <a16:creationId xmlns:a16="http://schemas.microsoft.com/office/drawing/2014/main" id="{BED0D359-651C-8C84-F319-3781F37936E4}"/>
                  </a:ext>
                </a:extLst>
              </p:cNvPr>
              <p:cNvSpPr/>
              <p:nvPr/>
            </p:nvSpPr>
            <p:spPr>
              <a:xfrm>
                <a:off x="1163638" y="4116776"/>
                <a:ext cx="2208212" cy="117572"/>
              </a:xfrm>
              <a:prstGeom prst="roundRect">
                <a:avLst>
                  <a:gd name="adj" fmla="val 50000"/>
                </a:avLst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" name="Rounded Rectangle 6">
                <a:extLst>
                  <a:ext uri="{FF2B5EF4-FFF2-40B4-BE49-F238E27FC236}">
                    <a16:creationId xmlns:a16="http://schemas.microsoft.com/office/drawing/2014/main" id="{B98CE6B5-436D-FD26-96ED-19199A845EB5}"/>
                  </a:ext>
                </a:extLst>
              </p:cNvPr>
              <p:cNvSpPr/>
              <p:nvPr/>
            </p:nvSpPr>
            <p:spPr>
              <a:xfrm>
                <a:off x="1282700" y="4116779"/>
                <a:ext cx="260350" cy="117572"/>
              </a:xfrm>
              <a:prstGeom prst="roundRect">
                <a:avLst>
                  <a:gd name="adj" fmla="val 36498"/>
                </a:avLst>
              </a:prstGeom>
              <a:solidFill>
                <a:srgbClr val="00A77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8" name="Rounded Rectangle 7">
                <a:extLst>
                  <a:ext uri="{FF2B5EF4-FFF2-40B4-BE49-F238E27FC236}">
                    <a16:creationId xmlns:a16="http://schemas.microsoft.com/office/drawing/2014/main" id="{7F3FC514-9153-0C90-453E-49FFCE856BDF}"/>
                  </a:ext>
                </a:extLst>
              </p:cNvPr>
              <p:cNvSpPr/>
              <p:nvPr/>
            </p:nvSpPr>
            <p:spPr>
              <a:xfrm>
                <a:off x="1860550" y="4116776"/>
                <a:ext cx="1041400" cy="117572"/>
              </a:xfrm>
              <a:prstGeom prst="roundRect">
                <a:avLst>
                  <a:gd name="adj" fmla="val 36498"/>
                </a:avLst>
              </a:prstGeom>
              <a:solidFill>
                <a:srgbClr val="007AA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3F69CB3-97B3-E649-3B7D-93D0FAB75CC5}"/>
                  </a:ext>
                </a:extLst>
              </p:cNvPr>
              <p:cNvSpPr txBox="1"/>
              <p:nvPr/>
            </p:nvSpPr>
            <p:spPr>
              <a:xfrm>
                <a:off x="1250811" y="4075535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700" dirty="0"/>
                  <a:t>BTB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15A1245-3522-DA8E-930E-7101357FD70C}"/>
                  </a:ext>
                </a:extLst>
              </p:cNvPr>
              <p:cNvSpPr txBox="1"/>
              <p:nvPr/>
            </p:nvSpPr>
            <p:spPr>
              <a:xfrm>
                <a:off x="2186325" y="4075535"/>
                <a:ext cx="38985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700" dirty="0"/>
                  <a:t>NPH3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44089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44</TotalTime>
  <Words>50</Words>
  <Application>Microsoft Macintosh PowerPoint</Application>
  <PresentationFormat>A4 Paper (210x297 mm)</PresentationFormat>
  <Paragraphs>3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Christie</dc:creator>
  <cp:lastModifiedBy>John Christie</cp:lastModifiedBy>
  <cp:revision>174</cp:revision>
  <cp:lastPrinted>2022-02-17T11:15:02Z</cp:lastPrinted>
  <dcterms:created xsi:type="dcterms:W3CDTF">2022-02-15T12:07:23Z</dcterms:created>
  <dcterms:modified xsi:type="dcterms:W3CDTF">2023-03-03T10:26:06Z</dcterms:modified>
</cp:coreProperties>
</file>